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9" r:id="rId2"/>
    <p:sldId id="260" r:id="rId3"/>
    <p:sldId id="258" r:id="rId4"/>
    <p:sldId id="257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89" autoAdjust="0"/>
    <p:restoredTop sz="94660"/>
  </p:normalViewPr>
  <p:slideViewPr>
    <p:cSldViewPr snapToGrid="0">
      <p:cViewPr>
        <p:scale>
          <a:sx n="80" d="100"/>
          <a:sy n="80" d="100"/>
        </p:scale>
        <p:origin x="1313" y="-11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0" d="100"/>
        <a:sy n="13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672212101084394"/>
          <c:y val="3.4037383052331359E-2"/>
          <c:w val="0.88965191022220946"/>
          <c:h val="0.82910330256419418"/>
        </c:manualLayout>
      </c:layout>
      <c:lineChart>
        <c:grouping val="standard"/>
        <c:varyColors val="0"/>
        <c:ser>
          <c:idx val="0"/>
          <c:order val="0"/>
          <c:tx>
            <c:strRef>
              <c:f>SAS!$B$19:$C$19</c:f>
              <c:strCache>
                <c:ptCount val="2"/>
                <c:pt idx="0">
                  <c:v>mock</c:v>
                </c:pt>
              </c:strCache>
            </c:strRef>
          </c:tx>
          <c:spPr>
            <a:ln w="28575" cap="rnd">
              <a:solidFill>
                <a:schemeClr val="bg2">
                  <a:lumMod val="90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AS!$O$3</c:f>
                <c:numCache>
                  <c:formatCode>General</c:formatCode>
                  <c:ptCount val="1"/>
                  <c:pt idx="0">
                    <c:v>6.5319726474218083</c:v>
                  </c:pt>
                </c:numCache>
              </c:numRef>
            </c:plus>
            <c:minus>
              <c:numRef>
                <c:f>SAS!$O$3</c:f>
                <c:numCache>
                  <c:formatCode>General</c:formatCode>
                  <c:ptCount val="1"/>
                  <c:pt idx="0">
                    <c:v>6.53197264742180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AS!$D$18:$I$18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SAS!$D$19:$I$19</c:f>
              <c:numCache>
                <c:formatCode>General</c:formatCode>
                <c:ptCount val="6"/>
                <c:pt idx="0">
                  <c:v>5</c:v>
                </c:pt>
                <c:pt idx="1">
                  <c:v>11.526666666666666</c:v>
                </c:pt>
                <c:pt idx="2">
                  <c:v>30.166666666666668</c:v>
                </c:pt>
                <c:pt idx="3">
                  <c:v>79.633333333333326</c:v>
                </c:pt>
                <c:pt idx="4">
                  <c:v>145.33333333333334</c:v>
                </c:pt>
                <c:pt idx="5">
                  <c:v>1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C15-4390-A50F-3584DEE1B1B4}"/>
            </c:ext>
          </c:extLst>
        </c:ser>
        <c:ser>
          <c:idx val="1"/>
          <c:order val="1"/>
          <c:tx>
            <c:strRef>
              <c:f>SAS!$B$20:$C$20</c:f>
              <c:strCache>
                <c:ptCount val="2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bg2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AS!$O$6</c:f>
                <c:numCache>
                  <c:formatCode>General</c:formatCode>
                  <c:ptCount val="1"/>
                  <c:pt idx="0">
                    <c:v>2.4944382578492941</c:v>
                  </c:pt>
                </c:numCache>
              </c:numRef>
            </c:plus>
            <c:minus>
              <c:numRef>
                <c:f>SAS!$O$6</c:f>
                <c:numCache>
                  <c:formatCode>General</c:formatCode>
                  <c:ptCount val="1"/>
                  <c:pt idx="0">
                    <c:v>2.49443825784929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AS!$D$18:$I$18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SAS!$D$20:$I$20</c:f>
              <c:numCache>
                <c:formatCode>General</c:formatCode>
                <c:ptCount val="6"/>
                <c:pt idx="0">
                  <c:v>5</c:v>
                </c:pt>
                <c:pt idx="1">
                  <c:v>12.75</c:v>
                </c:pt>
                <c:pt idx="2">
                  <c:v>29.933333333333334</c:v>
                </c:pt>
                <c:pt idx="3">
                  <c:v>81</c:v>
                </c:pt>
                <c:pt idx="4">
                  <c:v>151</c:v>
                </c:pt>
                <c:pt idx="5">
                  <c:v>157.66666666666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C15-4390-A50F-3584DEE1B1B4}"/>
            </c:ext>
          </c:extLst>
        </c:ser>
        <c:ser>
          <c:idx val="2"/>
          <c:order val="2"/>
          <c:tx>
            <c:strRef>
              <c:f>SAS!$B$21:$C$21</c:f>
              <c:strCache>
                <c:ptCount val="2"/>
                <c:pt idx="0">
                  <c:v>miR-31-5p-Inhibitor</c:v>
                </c:pt>
              </c:strCache>
            </c:strRef>
          </c:tx>
          <c:spPr>
            <a:ln w="28575" cap="rnd">
              <a:solidFill>
                <a:schemeClr val="bg2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AS!$O$12</c:f>
                <c:numCache>
                  <c:formatCode>General</c:formatCode>
                  <c:ptCount val="1"/>
                  <c:pt idx="0">
                    <c:v>1.247219128924647</c:v>
                  </c:pt>
                </c:numCache>
              </c:numRef>
            </c:plus>
            <c:minus>
              <c:numRef>
                <c:f>SAS!$O$12</c:f>
                <c:numCache>
                  <c:formatCode>General</c:formatCode>
                  <c:ptCount val="1"/>
                  <c:pt idx="0">
                    <c:v>1.2472191289246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AS!$D$18:$I$18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SAS!$D$21:$I$21</c:f>
              <c:numCache>
                <c:formatCode>General</c:formatCode>
                <c:ptCount val="6"/>
                <c:pt idx="0">
                  <c:v>5</c:v>
                </c:pt>
                <c:pt idx="1">
                  <c:v>10.226666666666667</c:v>
                </c:pt>
                <c:pt idx="2">
                  <c:v>18.933333333333334</c:v>
                </c:pt>
                <c:pt idx="3">
                  <c:v>53.933333333333337</c:v>
                </c:pt>
                <c:pt idx="4">
                  <c:v>92.133333333333326</c:v>
                </c:pt>
                <c:pt idx="5">
                  <c:v>117.6666666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C15-4390-A50F-3584DEE1B1B4}"/>
            </c:ext>
          </c:extLst>
        </c:ser>
        <c:ser>
          <c:idx val="3"/>
          <c:order val="3"/>
          <c:tx>
            <c:strRef>
              <c:f>SAS!$B$22:$C$22</c:f>
              <c:strCache>
                <c:ptCount val="2"/>
                <c:pt idx="0">
                  <c:v>miR-31-3p-Inhibitor</c:v>
                </c:pt>
              </c:strCache>
            </c:strRef>
          </c:tx>
          <c:spPr>
            <a:ln w="28575" cap="rnd">
              <a:solidFill>
                <a:schemeClr val="bg2">
                  <a:lumMod val="25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AS!$D$18:$I$18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SAS!$D$22:$I$22</c:f>
              <c:numCache>
                <c:formatCode>General</c:formatCode>
                <c:ptCount val="6"/>
                <c:pt idx="0">
                  <c:v>5</c:v>
                </c:pt>
                <c:pt idx="1">
                  <c:v>10.7</c:v>
                </c:pt>
                <c:pt idx="2">
                  <c:v>19.133333333333333</c:v>
                </c:pt>
                <c:pt idx="3">
                  <c:v>55.033333333333331</c:v>
                </c:pt>
                <c:pt idx="4">
                  <c:v>103.46666666666665</c:v>
                </c:pt>
                <c:pt idx="5">
                  <c:v>125.333333333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C15-4390-A50F-3584DEE1B1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72738592"/>
        <c:axId val="1572739008"/>
      </c:lineChart>
      <c:catAx>
        <c:axId val="1572738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72739008"/>
        <c:crosses val="autoZero"/>
        <c:auto val="1"/>
        <c:lblAlgn val="ctr"/>
        <c:lblOffset val="100"/>
        <c:noMultiLvlLbl val="0"/>
      </c:catAx>
      <c:valAx>
        <c:axId val="157273900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7273859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</c:legendEntry>
      <c:legendEntry>
        <c:idx val="3"/>
        <c:txPr>
          <a:bodyPr rot="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10545050069449366"/>
          <c:y val="3.7734084427941073E-2"/>
          <c:w val="0.51518093518515062"/>
          <c:h val="0.27142997865703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672214344454176"/>
          <c:y val="3.2034839131235511E-2"/>
          <c:w val="0.87406242735593032"/>
          <c:h val="0.82910330256419418"/>
        </c:manualLayout>
      </c:layout>
      <c:lineChart>
        <c:grouping val="standard"/>
        <c:varyColors val="0"/>
        <c:ser>
          <c:idx val="0"/>
          <c:order val="0"/>
          <c:tx>
            <c:strRef>
              <c:f>'HSC-2'!$B$19:$C$19</c:f>
              <c:strCache>
                <c:ptCount val="2"/>
                <c:pt idx="0">
                  <c:v>mock</c:v>
                </c:pt>
              </c:strCache>
            </c:strRef>
          </c:tx>
          <c:spPr>
            <a:ln w="28575" cap="rnd">
              <a:solidFill>
                <a:schemeClr val="bg2">
                  <a:lumMod val="90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HSC-2'!$C$25:$H$2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34393151773120345</c:v>
                  </c:pt>
                  <c:pt idx="2">
                    <c:v>0.61282587702834113</c:v>
                  </c:pt>
                  <c:pt idx="3">
                    <c:v>0.98994949366116602</c:v>
                  </c:pt>
                  <c:pt idx="4">
                    <c:v>1.5584892970081248</c:v>
                  </c:pt>
                  <c:pt idx="5">
                    <c:v>2.8674417556808756</c:v>
                  </c:pt>
                </c:numCache>
              </c:numRef>
            </c:plus>
            <c:minus>
              <c:numRef>
                <c:f>'HSC-2'!$C$25:$H$2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34393151773120345</c:v>
                  </c:pt>
                  <c:pt idx="2">
                    <c:v>0.61282587702834113</c:v>
                  </c:pt>
                  <c:pt idx="3">
                    <c:v>0.98994949366116602</c:v>
                  </c:pt>
                  <c:pt idx="4">
                    <c:v>1.5584892970081248</c:v>
                  </c:pt>
                  <c:pt idx="5">
                    <c:v>2.86744175568087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HSC-2'!$D$18:$I$18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'HSC-2'!$D$19:$I$19</c:f>
              <c:numCache>
                <c:formatCode>General</c:formatCode>
                <c:ptCount val="6"/>
                <c:pt idx="0">
                  <c:v>5</c:v>
                </c:pt>
                <c:pt idx="1">
                  <c:v>8.0066666666666659</c:v>
                </c:pt>
                <c:pt idx="2">
                  <c:v>11.333333333333334</c:v>
                </c:pt>
                <c:pt idx="3">
                  <c:v>31.900000000000002</c:v>
                </c:pt>
                <c:pt idx="4">
                  <c:v>79.066666666666663</c:v>
                </c:pt>
                <c:pt idx="5">
                  <c:v>151.3333333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14F-4E9B-B5D4-135F35F7E503}"/>
            </c:ext>
          </c:extLst>
        </c:ser>
        <c:ser>
          <c:idx val="1"/>
          <c:order val="1"/>
          <c:tx>
            <c:strRef>
              <c:f>'HSC-2'!$B$20:$C$20</c:f>
              <c:strCache>
                <c:ptCount val="2"/>
                <c:pt idx="0">
                  <c:v>control</c:v>
                </c:pt>
              </c:strCache>
            </c:strRef>
          </c:tx>
          <c:spPr>
            <a:ln w="28575" cap="rnd">
              <a:solidFill>
                <a:schemeClr val="bg2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HSC-2'!$C$26:$H$26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2327134623427613</c:v>
                  </c:pt>
                  <c:pt idx="2">
                    <c:v>0.75</c:v>
                  </c:pt>
                  <c:pt idx="3">
                    <c:v>0.44999999999999929</c:v>
                  </c:pt>
                  <c:pt idx="4">
                    <c:v>1.7907168024751039</c:v>
                  </c:pt>
                  <c:pt idx="5">
                    <c:v>2.9439202887759488</c:v>
                  </c:pt>
                </c:numCache>
              </c:numRef>
            </c:plus>
            <c:minus>
              <c:numRef>
                <c:f>'HSC-2'!$C$26:$H$26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2327134623427613</c:v>
                  </c:pt>
                  <c:pt idx="2">
                    <c:v>0.75</c:v>
                  </c:pt>
                  <c:pt idx="3">
                    <c:v>0.44999999999999929</c:v>
                  </c:pt>
                  <c:pt idx="4">
                    <c:v>1.7907168024751039</c:v>
                  </c:pt>
                  <c:pt idx="5">
                    <c:v>2.94392028877594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HSC-2'!$D$18:$I$18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'HSC-2'!$D$20:$I$20</c:f>
              <c:numCache>
                <c:formatCode>General</c:formatCode>
                <c:ptCount val="6"/>
                <c:pt idx="0">
                  <c:v>5</c:v>
                </c:pt>
                <c:pt idx="1">
                  <c:v>7.81</c:v>
                </c:pt>
                <c:pt idx="2">
                  <c:v>11.45</c:v>
                </c:pt>
                <c:pt idx="3">
                  <c:v>30.2</c:v>
                </c:pt>
                <c:pt idx="4">
                  <c:v>79.599999999999994</c:v>
                </c:pt>
                <c:pt idx="5">
                  <c:v>148.3333333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14F-4E9B-B5D4-135F35F7E503}"/>
            </c:ext>
          </c:extLst>
        </c:ser>
        <c:ser>
          <c:idx val="2"/>
          <c:order val="2"/>
          <c:tx>
            <c:strRef>
              <c:f>'HSC-2'!$B$21:$C$21</c:f>
              <c:strCache>
                <c:ptCount val="2"/>
                <c:pt idx="0">
                  <c:v>miR-31-5p-Inhibitor</c:v>
                </c:pt>
              </c:strCache>
            </c:strRef>
          </c:tx>
          <c:spPr>
            <a:ln w="28575" cap="rnd">
              <a:solidFill>
                <a:schemeClr val="bg2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HSC-2'!$C$27:$H$2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22050447211388308</c:v>
                  </c:pt>
                  <c:pt idx="2">
                    <c:v>0.20000000000000018</c:v>
                  </c:pt>
                  <c:pt idx="3">
                    <c:v>1.5500000000000007</c:v>
                  </c:pt>
                  <c:pt idx="4">
                    <c:v>0.61824123303304912</c:v>
                  </c:pt>
                  <c:pt idx="5">
                    <c:v>0.81649658092772603</c:v>
                  </c:pt>
                </c:numCache>
              </c:numRef>
            </c:plus>
            <c:minus>
              <c:numRef>
                <c:f>'HSC-2'!$C$27:$H$2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22050447211388308</c:v>
                  </c:pt>
                  <c:pt idx="2">
                    <c:v>0.20000000000000018</c:v>
                  </c:pt>
                  <c:pt idx="3">
                    <c:v>1.5500000000000007</c:v>
                  </c:pt>
                  <c:pt idx="4">
                    <c:v>0.61824123303304912</c:v>
                  </c:pt>
                  <c:pt idx="5">
                    <c:v>0.816496580927726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HSC-2'!$D$18:$I$18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'HSC-2'!$D$21:$I$21</c:f>
              <c:numCache>
                <c:formatCode>General</c:formatCode>
                <c:ptCount val="6"/>
                <c:pt idx="0">
                  <c:v>5</c:v>
                </c:pt>
                <c:pt idx="1">
                  <c:v>7.4666666666666659</c:v>
                </c:pt>
                <c:pt idx="2">
                  <c:v>10.083333333333334</c:v>
                </c:pt>
                <c:pt idx="3">
                  <c:v>25.466666666666669</c:v>
                </c:pt>
                <c:pt idx="4">
                  <c:v>55.666666666666664</c:v>
                </c:pt>
                <c:pt idx="5">
                  <c:v>90.5333333333333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14F-4E9B-B5D4-135F35F7E503}"/>
            </c:ext>
          </c:extLst>
        </c:ser>
        <c:ser>
          <c:idx val="3"/>
          <c:order val="3"/>
          <c:tx>
            <c:strRef>
              <c:f>'HSC-2'!$B$22:$C$22</c:f>
              <c:strCache>
                <c:ptCount val="2"/>
                <c:pt idx="0">
                  <c:v>miR-31-3p-Inhibitor</c:v>
                </c:pt>
              </c:strCache>
            </c:strRef>
          </c:tx>
          <c:spPr>
            <a:ln w="28575" cap="rnd">
              <a:solidFill>
                <a:schemeClr val="bg2">
                  <a:lumMod val="25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HSC-2'!$C$28:$H$28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21228911104120896</c:v>
                  </c:pt>
                  <c:pt idx="2">
                    <c:v>1.25</c:v>
                  </c:pt>
                  <c:pt idx="3">
                    <c:v>0.30000000000000071</c:v>
                  </c:pt>
                  <c:pt idx="4">
                    <c:v>1.49666295470958</c:v>
                  </c:pt>
                  <c:pt idx="5">
                    <c:v>1.699673171197595</c:v>
                  </c:pt>
                </c:numCache>
              </c:numRef>
            </c:plus>
            <c:minus>
              <c:numRef>
                <c:f>'HSC-2'!$C$28:$H$28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21228911104120896</c:v>
                  </c:pt>
                  <c:pt idx="2">
                    <c:v>1.25</c:v>
                  </c:pt>
                  <c:pt idx="3">
                    <c:v>0.30000000000000071</c:v>
                  </c:pt>
                  <c:pt idx="4">
                    <c:v>1.49666295470958</c:v>
                  </c:pt>
                  <c:pt idx="5">
                    <c:v>1.6996731711975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HSC-2'!$D$18:$I$18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'HSC-2'!$D$22:$I$22</c:f>
              <c:numCache>
                <c:formatCode>General</c:formatCode>
                <c:ptCount val="6"/>
                <c:pt idx="0">
                  <c:v>5</c:v>
                </c:pt>
                <c:pt idx="1">
                  <c:v>7.32</c:v>
                </c:pt>
                <c:pt idx="2">
                  <c:v>10.623333333333333</c:v>
                </c:pt>
                <c:pt idx="3">
                  <c:v>28.266666666666666</c:v>
                </c:pt>
                <c:pt idx="4">
                  <c:v>61.333333333333336</c:v>
                </c:pt>
                <c:pt idx="5">
                  <c:v>107.333333333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14F-4E9B-B5D4-135F35F7E5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72738592"/>
        <c:axId val="1572739008"/>
      </c:lineChart>
      <c:catAx>
        <c:axId val="1572738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72739008"/>
        <c:crosses val="autoZero"/>
        <c:auto val="1"/>
        <c:lblAlgn val="ctr"/>
        <c:lblOffset val="100"/>
        <c:noMultiLvlLbl val="0"/>
      </c:catAx>
      <c:valAx>
        <c:axId val="157273900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7273859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</c:legendEntry>
      <c:legendEntry>
        <c:idx val="3"/>
        <c:txPr>
          <a:bodyPr rot="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11467754754656904"/>
          <c:y val="4.1528971369438561E-2"/>
          <c:w val="0.50514436589434109"/>
          <c:h val="0.2437262790310593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7956</cdr:x>
      <cdr:y>0.63946</cdr:y>
    </cdr:from>
    <cdr:to>
      <cdr:x>0.69932</cdr:x>
      <cdr:y>0.70089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BA6FBA29-9B15-4A6F-8C9C-7D2CBCF0641A}"/>
            </a:ext>
          </a:extLst>
        </cdr:cNvPr>
        <cdr:cNvSpPr txBox="1"/>
      </cdr:nvSpPr>
      <cdr:spPr>
        <a:xfrm xmlns:a="http://schemas.openxmlformats.org/drawingml/2006/main">
          <a:off x="1649184" y="2242641"/>
          <a:ext cx="340785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rPr>
            <a:t>＊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D96D-4BF7-4F11-9C0D-209F827A171E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17F10-679C-4411-98E6-880EF8175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0712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D96D-4BF7-4F11-9C0D-209F827A171E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17F10-679C-4411-98E6-880EF8175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4886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D96D-4BF7-4F11-9C0D-209F827A171E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17F10-679C-4411-98E6-880EF8175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2876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D96D-4BF7-4F11-9C0D-209F827A171E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17F10-679C-4411-98E6-880EF8175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86489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D96D-4BF7-4F11-9C0D-209F827A171E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17F10-679C-4411-98E6-880EF8175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7440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D96D-4BF7-4F11-9C0D-209F827A171E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17F10-679C-4411-98E6-880EF8175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3514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D96D-4BF7-4F11-9C0D-209F827A171E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17F10-679C-4411-98E6-880EF8175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086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D96D-4BF7-4F11-9C0D-209F827A171E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17F10-679C-4411-98E6-880EF8175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2033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D96D-4BF7-4F11-9C0D-209F827A171E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17F10-679C-4411-98E6-880EF8175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6730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D96D-4BF7-4F11-9C0D-209F827A171E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17F10-679C-4411-98E6-880EF8175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34797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ED96D-4BF7-4F11-9C0D-209F827A171E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17F10-679C-4411-98E6-880EF8175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50714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9ED96D-4BF7-4F11-9C0D-209F827A171E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417F10-679C-4411-98E6-880EF8175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62741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microsoft.com/office/2007/relationships/hdphoto" Target="../media/hdphoto5.wdp"/><Relationship Id="rId18" Type="http://schemas.openxmlformats.org/officeDocument/2006/relationships/image" Target="../media/image10.jpeg"/><Relationship Id="rId26" Type="http://schemas.microsoft.com/office/2007/relationships/hdphoto" Target="../media/hdphoto10.wdp"/><Relationship Id="rId3" Type="http://schemas.microsoft.com/office/2007/relationships/hdphoto" Target="../media/hdphoto1.wdp"/><Relationship Id="rId21" Type="http://schemas.openxmlformats.org/officeDocument/2006/relationships/image" Target="../media/image13.png"/><Relationship Id="rId7" Type="http://schemas.openxmlformats.org/officeDocument/2006/relationships/image" Target="../media/image4.jpeg"/><Relationship Id="rId12" Type="http://schemas.openxmlformats.org/officeDocument/2006/relationships/image" Target="../media/image7.png"/><Relationship Id="rId17" Type="http://schemas.microsoft.com/office/2007/relationships/hdphoto" Target="../media/hdphoto7.wdp"/><Relationship Id="rId25" Type="http://schemas.openxmlformats.org/officeDocument/2006/relationships/image" Target="../media/image15.png"/><Relationship Id="rId2" Type="http://schemas.openxmlformats.org/officeDocument/2006/relationships/image" Target="../media/image1.png"/><Relationship Id="rId16" Type="http://schemas.openxmlformats.org/officeDocument/2006/relationships/image" Target="../media/image9.png"/><Relationship Id="rId20" Type="http://schemas.openxmlformats.org/officeDocument/2006/relationships/image" Target="../media/image1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11" Type="http://schemas.microsoft.com/office/2007/relationships/hdphoto" Target="../media/hdphoto4.wdp"/><Relationship Id="rId24" Type="http://schemas.microsoft.com/office/2007/relationships/hdphoto" Target="../media/hdphoto9.wdp"/><Relationship Id="rId5" Type="http://schemas.microsoft.com/office/2007/relationships/hdphoto" Target="../media/hdphoto2.wdp"/><Relationship Id="rId15" Type="http://schemas.microsoft.com/office/2007/relationships/hdphoto" Target="../media/hdphoto6.wdp"/><Relationship Id="rId23" Type="http://schemas.openxmlformats.org/officeDocument/2006/relationships/image" Target="../media/image14.png"/><Relationship Id="rId28" Type="http://schemas.microsoft.com/office/2007/relationships/hdphoto" Target="../media/hdphoto11.wdp"/><Relationship Id="rId10" Type="http://schemas.openxmlformats.org/officeDocument/2006/relationships/image" Target="../media/image6.png"/><Relationship Id="rId19" Type="http://schemas.openxmlformats.org/officeDocument/2006/relationships/image" Target="../media/image11.jpeg"/><Relationship Id="rId4" Type="http://schemas.openxmlformats.org/officeDocument/2006/relationships/image" Target="../media/image2.png"/><Relationship Id="rId9" Type="http://schemas.microsoft.com/office/2007/relationships/hdphoto" Target="../media/hdphoto3.wdp"/><Relationship Id="rId14" Type="http://schemas.openxmlformats.org/officeDocument/2006/relationships/image" Target="../media/image8.png"/><Relationship Id="rId22" Type="http://schemas.microsoft.com/office/2007/relationships/hdphoto" Target="../media/hdphoto8.wdp"/><Relationship Id="rId27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4A783D9-032B-48B8-961B-358AE89C8755}"/>
              </a:ext>
            </a:extLst>
          </p:cNvPr>
          <p:cNvSpPr txBox="1"/>
          <p:nvPr/>
        </p:nvSpPr>
        <p:spPr>
          <a:xfrm>
            <a:off x="216930" y="107912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BA5511F1-5818-465A-A0F7-556CFB9B7F18}"/>
              </a:ext>
            </a:extLst>
          </p:cNvPr>
          <p:cNvGrpSpPr/>
          <p:nvPr/>
        </p:nvGrpSpPr>
        <p:grpSpPr>
          <a:xfrm>
            <a:off x="1411461" y="940209"/>
            <a:ext cx="3895359" cy="3675907"/>
            <a:chOff x="1278801" y="854974"/>
            <a:chExt cx="3811090" cy="3290012"/>
          </a:xfrm>
        </p:grpSpPr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AE20499C-381C-40B1-9A34-6551FC8688B7}"/>
                </a:ext>
              </a:extLst>
            </p:cNvPr>
            <p:cNvGrpSpPr/>
            <p:nvPr/>
          </p:nvGrpSpPr>
          <p:grpSpPr>
            <a:xfrm>
              <a:off x="2037667" y="1143693"/>
              <a:ext cx="2807385" cy="2380015"/>
              <a:chOff x="2037667" y="1143693"/>
              <a:chExt cx="2807385" cy="2380015"/>
            </a:xfrm>
          </p:grpSpPr>
          <p:sp>
            <p:nvSpPr>
              <p:cNvPr id="39" name="Line 8">
                <a:extLst>
                  <a:ext uri="{FF2B5EF4-FFF2-40B4-BE49-F238E27FC236}">
                    <a16:creationId xmlns:a16="http://schemas.microsoft.com/office/drawing/2014/main" id="{1DB9D999-0234-4345-AE10-652EE90C78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72054" y="2967442"/>
                <a:ext cx="11141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0" name="Line 9">
                <a:extLst>
                  <a:ext uri="{FF2B5EF4-FFF2-40B4-BE49-F238E27FC236}">
                    <a16:creationId xmlns:a16="http://schemas.microsoft.com/office/drawing/2014/main" id="{6668D9DC-4F5B-4C9A-88F0-AF8B520E29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7074" y="2967442"/>
                <a:ext cx="0" cy="79602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1" name="Line 10">
                <a:extLst>
                  <a:ext uri="{FF2B5EF4-FFF2-40B4-BE49-F238E27FC236}">
                    <a16:creationId xmlns:a16="http://schemas.microsoft.com/office/drawing/2014/main" id="{C9E644B6-EDF6-43D1-83F9-521F150613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72054" y="3047044"/>
                <a:ext cx="11141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2" name="Line 11">
                <a:extLst>
                  <a:ext uri="{FF2B5EF4-FFF2-40B4-BE49-F238E27FC236}">
                    <a16:creationId xmlns:a16="http://schemas.microsoft.com/office/drawing/2014/main" id="{33C2D190-E4D4-4118-9CE2-8EAF46CC31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8007" y="2536736"/>
                <a:ext cx="110040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3" name="Line 12">
                <a:extLst>
                  <a:ext uri="{FF2B5EF4-FFF2-40B4-BE49-F238E27FC236}">
                    <a16:creationId xmlns:a16="http://schemas.microsoft.com/office/drawing/2014/main" id="{FD0C3A54-63BF-43B1-BFDA-66A8B458E0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3026" y="2536736"/>
                <a:ext cx="0" cy="122247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4" name="Line 13">
                <a:extLst>
                  <a:ext uri="{FF2B5EF4-FFF2-40B4-BE49-F238E27FC236}">
                    <a16:creationId xmlns:a16="http://schemas.microsoft.com/office/drawing/2014/main" id="{24EE6AB7-555E-4A48-AED2-AA26AE7CB2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8007" y="2658982"/>
                <a:ext cx="110040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" name="Line 14">
                <a:extLst>
                  <a:ext uri="{FF2B5EF4-FFF2-40B4-BE49-F238E27FC236}">
                    <a16:creationId xmlns:a16="http://schemas.microsoft.com/office/drawing/2014/main" id="{F4810FCB-6BEA-41F2-A7DF-0B215B9FEA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09462" y="1352650"/>
                <a:ext cx="11141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6" name="Line 15">
                <a:extLst>
                  <a:ext uri="{FF2B5EF4-FFF2-40B4-BE49-F238E27FC236}">
                    <a16:creationId xmlns:a16="http://schemas.microsoft.com/office/drawing/2014/main" id="{99BCEAC2-9A57-4135-B92D-1162C4FCA4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65857" y="1352650"/>
                <a:ext cx="0" cy="372426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7" name="Line 16">
                <a:extLst>
                  <a:ext uri="{FF2B5EF4-FFF2-40B4-BE49-F238E27FC236}">
                    <a16:creationId xmlns:a16="http://schemas.microsoft.com/office/drawing/2014/main" id="{4CDEA5D3-709E-4A9E-8409-0099E7CF94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09462" y="1725076"/>
                <a:ext cx="11141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8" name="Line 17">
                <a:extLst>
                  <a:ext uri="{FF2B5EF4-FFF2-40B4-BE49-F238E27FC236}">
                    <a16:creationId xmlns:a16="http://schemas.microsoft.com/office/drawing/2014/main" id="{B6EFCF3A-F232-4959-A459-E68AA33E59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5414" y="3247471"/>
                <a:ext cx="11141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" name="Line 18">
                <a:extLst>
                  <a:ext uri="{FF2B5EF4-FFF2-40B4-BE49-F238E27FC236}">
                    <a16:creationId xmlns:a16="http://schemas.microsoft.com/office/drawing/2014/main" id="{2AD23979-BED6-41A1-BA04-4426AECC59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80434" y="3247471"/>
                <a:ext cx="0" cy="65388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" name="Line 19">
                <a:extLst>
                  <a:ext uri="{FF2B5EF4-FFF2-40B4-BE49-F238E27FC236}">
                    <a16:creationId xmlns:a16="http://schemas.microsoft.com/office/drawing/2014/main" id="{932A0FFE-702A-468F-A191-31127BA1EE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5414" y="3312859"/>
                <a:ext cx="11141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" name="Line 20">
                <a:extLst>
                  <a:ext uri="{FF2B5EF4-FFF2-40B4-BE49-F238E27FC236}">
                    <a16:creationId xmlns:a16="http://schemas.microsoft.com/office/drawing/2014/main" id="{D1709B61-459F-4CDF-AAAF-02F4C00DB6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48244" y="1359757"/>
                <a:ext cx="11141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2" name="Line 21">
                <a:extLst>
                  <a:ext uri="{FF2B5EF4-FFF2-40B4-BE49-F238E27FC236}">
                    <a16:creationId xmlns:a16="http://schemas.microsoft.com/office/drawing/2014/main" id="{7534E1C6-FDC9-40D8-8B51-383BF19D66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03264" y="1359757"/>
                <a:ext cx="0" cy="28429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3" name="Line 22">
                <a:extLst>
                  <a:ext uri="{FF2B5EF4-FFF2-40B4-BE49-F238E27FC236}">
                    <a16:creationId xmlns:a16="http://schemas.microsoft.com/office/drawing/2014/main" id="{B5294A9E-4842-48B3-8899-92C2614D86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48244" y="1388186"/>
                <a:ext cx="11141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4" name="Line 23">
                <a:extLst>
                  <a:ext uri="{FF2B5EF4-FFF2-40B4-BE49-F238E27FC236}">
                    <a16:creationId xmlns:a16="http://schemas.microsoft.com/office/drawing/2014/main" id="{235F9A38-F3F2-4EFC-B500-8472EF22F4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2822" y="2451447"/>
                <a:ext cx="11141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5" name="Line 24">
                <a:extLst>
                  <a:ext uri="{FF2B5EF4-FFF2-40B4-BE49-F238E27FC236}">
                    <a16:creationId xmlns:a16="http://schemas.microsoft.com/office/drawing/2014/main" id="{DA2E1604-EC58-4CE8-BFAD-4F19E3DF99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19217" y="2451447"/>
                <a:ext cx="0" cy="143569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6" name="Line 25">
                <a:extLst>
                  <a:ext uri="{FF2B5EF4-FFF2-40B4-BE49-F238E27FC236}">
                    <a16:creationId xmlns:a16="http://schemas.microsoft.com/office/drawing/2014/main" id="{72867347-D7E9-4502-A837-873A26B742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2822" y="2595016"/>
                <a:ext cx="11141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7" name="Line 26">
                <a:extLst>
                  <a:ext uri="{FF2B5EF4-FFF2-40B4-BE49-F238E27FC236}">
                    <a16:creationId xmlns:a16="http://schemas.microsoft.com/office/drawing/2014/main" id="{D1115115-6109-4505-B7B7-A851086172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85652" y="1611358"/>
                <a:ext cx="104538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8" name="Line 27">
                <a:extLst>
                  <a:ext uri="{FF2B5EF4-FFF2-40B4-BE49-F238E27FC236}">
                    <a16:creationId xmlns:a16="http://schemas.microsoft.com/office/drawing/2014/main" id="{C0BA538E-0927-4622-9204-B238A92091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40672" y="1611358"/>
                <a:ext cx="0" cy="452028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9" name="Line 28">
                <a:extLst>
                  <a:ext uri="{FF2B5EF4-FFF2-40B4-BE49-F238E27FC236}">
                    <a16:creationId xmlns:a16="http://schemas.microsoft.com/office/drawing/2014/main" id="{228B1C68-A074-433D-B90B-8238D37524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85652" y="2063386"/>
                <a:ext cx="104538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0" name="Line 29">
                <a:extLst>
                  <a:ext uri="{FF2B5EF4-FFF2-40B4-BE49-F238E27FC236}">
                    <a16:creationId xmlns:a16="http://schemas.microsoft.com/office/drawing/2014/main" id="{670FDFF5-23AD-436A-B1C3-15B69149D3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01605" y="1143693"/>
                <a:ext cx="11141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1" name="Line 30">
                <a:extLst>
                  <a:ext uri="{FF2B5EF4-FFF2-40B4-BE49-F238E27FC236}">
                    <a16:creationId xmlns:a16="http://schemas.microsoft.com/office/drawing/2014/main" id="{A127B3C6-446B-457E-A748-AD74B1118B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56625" y="1143693"/>
                <a:ext cx="0" cy="754802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2" name="Line 31">
                <a:extLst>
                  <a:ext uri="{FF2B5EF4-FFF2-40B4-BE49-F238E27FC236}">
                    <a16:creationId xmlns:a16="http://schemas.microsoft.com/office/drawing/2014/main" id="{3CCE65C8-436F-4F1B-AC9E-E34BE07B72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01605" y="1898495"/>
                <a:ext cx="11141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3" name="Line 32">
                <a:extLst>
                  <a:ext uri="{FF2B5EF4-FFF2-40B4-BE49-F238E27FC236}">
                    <a16:creationId xmlns:a16="http://schemas.microsoft.com/office/drawing/2014/main" id="{0CDB1599-3C57-454A-B2A0-C775A1751D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23059" y="1905602"/>
                <a:ext cx="104538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4" name="Line 33">
                <a:extLst>
                  <a:ext uri="{FF2B5EF4-FFF2-40B4-BE49-F238E27FC236}">
                    <a16:creationId xmlns:a16="http://schemas.microsoft.com/office/drawing/2014/main" id="{617ECF4A-D5F4-40C9-B7C8-122B943BDC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79455" y="1905602"/>
                <a:ext cx="0" cy="179105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5" name="Line 34">
                <a:extLst>
                  <a:ext uri="{FF2B5EF4-FFF2-40B4-BE49-F238E27FC236}">
                    <a16:creationId xmlns:a16="http://schemas.microsoft.com/office/drawing/2014/main" id="{F5A45577-92A8-4E6C-AC63-70147807A9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23059" y="2084708"/>
                <a:ext cx="104538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6" name="Line 35">
                <a:extLst>
                  <a:ext uri="{FF2B5EF4-FFF2-40B4-BE49-F238E27FC236}">
                    <a16:creationId xmlns:a16="http://schemas.microsoft.com/office/drawing/2014/main" id="{3EA6688C-1F55-4A1F-BC5F-9F41D61159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39013" y="2120245"/>
                <a:ext cx="11141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7" name="Line 36">
                <a:extLst>
                  <a:ext uri="{FF2B5EF4-FFF2-40B4-BE49-F238E27FC236}">
                    <a16:creationId xmlns:a16="http://schemas.microsoft.com/office/drawing/2014/main" id="{18C3A48F-5F13-47BF-88FB-D67BE07A89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95407" y="2120245"/>
                <a:ext cx="0" cy="108032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8" name="Line 37">
                <a:extLst>
                  <a:ext uri="{FF2B5EF4-FFF2-40B4-BE49-F238E27FC236}">
                    <a16:creationId xmlns:a16="http://schemas.microsoft.com/office/drawing/2014/main" id="{3675D4D6-8E9C-46BB-8A40-6205539081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39013" y="2228277"/>
                <a:ext cx="11141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9" name="Line 38">
                <a:extLst>
                  <a:ext uri="{FF2B5EF4-FFF2-40B4-BE49-F238E27FC236}">
                    <a16:creationId xmlns:a16="http://schemas.microsoft.com/office/drawing/2014/main" id="{32D47B02-E1E0-47CC-AAC4-C3D7618D00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61843" y="1675324"/>
                <a:ext cx="104538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0" name="Line 39">
                <a:extLst>
                  <a:ext uri="{FF2B5EF4-FFF2-40B4-BE49-F238E27FC236}">
                    <a16:creationId xmlns:a16="http://schemas.microsoft.com/office/drawing/2014/main" id="{90CAE41C-F0F4-446E-9175-223B004C4C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09985" y="1675324"/>
                <a:ext cx="0" cy="28429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1" name="Line 40">
                <a:extLst>
                  <a:ext uri="{FF2B5EF4-FFF2-40B4-BE49-F238E27FC236}">
                    <a16:creationId xmlns:a16="http://schemas.microsoft.com/office/drawing/2014/main" id="{A96F4D9E-D858-48DE-BBCF-9426C36E3D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61843" y="1703753"/>
                <a:ext cx="104538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2" name="Line 41">
                <a:extLst>
                  <a:ext uri="{FF2B5EF4-FFF2-40B4-BE49-F238E27FC236}">
                    <a16:creationId xmlns:a16="http://schemas.microsoft.com/office/drawing/2014/main" id="{FFF42D79-1B0F-4836-A915-E95B95FAB0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77795" y="2694519"/>
                <a:ext cx="110040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3" name="Line 42">
                <a:extLst>
                  <a:ext uri="{FF2B5EF4-FFF2-40B4-BE49-F238E27FC236}">
                    <a16:creationId xmlns:a16="http://schemas.microsoft.com/office/drawing/2014/main" id="{ED53FCD4-F4E2-47D2-9E8D-5AC071183E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32815" y="2694519"/>
                <a:ext cx="0" cy="143569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4" name="Line 43">
                <a:extLst>
                  <a:ext uri="{FF2B5EF4-FFF2-40B4-BE49-F238E27FC236}">
                    <a16:creationId xmlns:a16="http://schemas.microsoft.com/office/drawing/2014/main" id="{6C5D74AA-8DA9-489A-AA27-0550F085C6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77795" y="2838088"/>
                <a:ext cx="110040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5" name="Line 44">
                <a:extLst>
                  <a:ext uri="{FF2B5EF4-FFF2-40B4-BE49-F238E27FC236}">
                    <a16:creationId xmlns:a16="http://schemas.microsoft.com/office/drawing/2014/main" id="{70F91FA4-DE9E-4D79-8126-0C3597E84B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92372" y="3140862"/>
                <a:ext cx="11141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6" name="Line 45">
                <a:extLst>
                  <a:ext uri="{FF2B5EF4-FFF2-40B4-BE49-F238E27FC236}">
                    <a16:creationId xmlns:a16="http://schemas.microsoft.com/office/drawing/2014/main" id="{B89C1BA9-072E-442A-8504-4FCB4F4BAD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48768" y="3140862"/>
                <a:ext cx="0" cy="35537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" name="Line 46">
                <a:extLst>
                  <a:ext uri="{FF2B5EF4-FFF2-40B4-BE49-F238E27FC236}">
                    <a16:creationId xmlns:a16="http://schemas.microsoft.com/office/drawing/2014/main" id="{B1EEB1C2-1E47-451F-AA30-E41824EC55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92372" y="3176398"/>
                <a:ext cx="111416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8" name="Rectangle 48">
                <a:extLst>
                  <a:ext uri="{FF2B5EF4-FFF2-40B4-BE49-F238E27FC236}">
                    <a16:creationId xmlns:a16="http://schemas.microsoft.com/office/drawing/2014/main" id="{28CC265A-E995-4EFA-88F6-83C386C55F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37667" y="3011508"/>
                <a:ext cx="180190" cy="508887"/>
              </a:xfrm>
              <a:prstGeom prst="rect">
                <a:avLst/>
              </a:prstGeom>
              <a:solidFill>
                <a:schemeClr val="tx1"/>
              </a:solidFill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" name="Rectangle 50">
                <a:extLst>
                  <a:ext uri="{FF2B5EF4-FFF2-40B4-BE49-F238E27FC236}">
                    <a16:creationId xmlns:a16="http://schemas.microsoft.com/office/drawing/2014/main" id="{B26E9308-2189-441B-87D0-1B21A62B45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2244" y="2605437"/>
                <a:ext cx="188443" cy="918271"/>
              </a:xfrm>
              <a:prstGeom prst="rect">
                <a:avLst/>
              </a:prstGeom>
              <a:solidFill>
                <a:schemeClr val="tx1"/>
              </a:solidFill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0" name="Rectangle 52">
                <a:extLst>
                  <a:ext uri="{FF2B5EF4-FFF2-40B4-BE49-F238E27FC236}">
                    <a16:creationId xmlns:a16="http://schemas.microsoft.com/office/drawing/2014/main" id="{59440A30-78FA-40C7-B95D-30F58969F7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68197" y="1542176"/>
                <a:ext cx="187067" cy="1981532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" name="Rectangle 54">
                <a:extLst>
                  <a:ext uri="{FF2B5EF4-FFF2-40B4-BE49-F238E27FC236}">
                    <a16:creationId xmlns:a16="http://schemas.microsoft.com/office/drawing/2014/main" id="{F8BB81C8-AF8D-470A-9D4E-47721139F0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1027" y="3280636"/>
                <a:ext cx="187067" cy="243072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" name="Rectangle 56">
                <a:extLst>
                  <a:ext uri="{FF2B5EF4-FFF2-40B4-BE49-F238E27FC236}">
                    <a16:creationId xmlns:a16="http://schemas.microsoft.com/office/drawing/2014/main" id="{DB584D69-61F3-41D5-B6B2-1D73FE3F39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05604" y="1377286"/>
                <a:ext cx="188443" cy="2146422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" name="Rectangle 58">
                <a:extLst>
                  <a:ext uri="{FF2B5EF4-FFF2-40B4-BE49-F238E27FC236}">
                    <a16:creationId xmlns:a16="http://schemas.microsoft.com/office/drawing/2014/main" id="{1762AF9A-7B7B-4670-B51F-434477755A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8435" y="2525835"/>
                <a:ext cx="188443" cy="99787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" name="Rectangle 60">
                <a:extLst>
                  <a:ext uri="{FF2B5EF4-FFF2-40B4-BE49-F238E27FC236}">
                    <a16:creationId xmlns:a16="http://schemas.microsoft.com/office/drawing/2014/main" id="{4D02578E-957A-4889-93D8-1386ADAC36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44387" y="1836421"/>
                <a:ext cx="187067" cy="1687287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" name="Rectangle 62">
                <a:extLst>
                  <a:ext uri="{FF2B5EF4-FFF2-40B4-BE49-F238E27FC236}">
                    <a16:creationId xmlns:a16="http://schemas.microsoft.com/office/drawing/2014/main" id="{A8CC0F49-3E0A-414F-BF17-27AD6A747B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65842" y="1520854"/>
                <a:ext cx="181565" cy="2002854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6" name="Rectangle 64">
                <a:extLst>
                  <a:ext uri="{FF2B5EF4-FFF2-40B4-BE49-F238E27FC236}">
                    <a16:creationId xmlns:a16="http://schemas.microsoft.com/office/drawing/2014/main" id="{0A445B21-DA0C-4745-87CC-1F1025C930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1795" y="2001311"/>
                <a:ext cx="188443" cy="1522397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7" name="Rectangle 66">
                <a:extLst>
                  <a:ext uri="{FF2B5EF4-FFF2-40B4-BE49-F238E27FC236}">
                    <a16:creationId xmlns:a16="http://schemas.microsoft.com/office/drawing/2014/main" id="{96210B4C-7F45-4173-8B77-C2C6F5EA9A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4625" y="2181839"/>
                <a:ext cx="180190" cy="1341869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8" name="Rectangle 68">
                <a:extLst>
                  <a:ext uri="{FF2B5EF4-FFF2-40B4-BE49-F238E27FC236}">
                    <a16:creationId xmlns:a16="http://schemas.microsoft.com/office/drawing/2014/main" id="{E120E932-2A52-40B1-A788-3CEB2FE3D8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20578" y="1692852"/>
                <a:ext cx="187067" cy="1830856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9" name="Rectangle 70">
                <a:extLst>
                  <a:ext uri="{FF2B5EF4-FFF2-40B4-BE49-F238E27FC236}">
                    <a16:creationId xmlns:a16="http://schemas.microsoft.com/office/drawing/2014/main" id="{BDD31D25-6214-4E75-A067-3B86503EE2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2032" y="2770328"/>
                <a:ext cx="181565" cy="75338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0" name="Rectangle 72">
                <a:extLst>
                  <a:ext uri="{FF2B5EF4-FFF2-40B4-BE49-F238E27FC236}">
                    <a16:creationId xmlns:a16="http://schemas.microsoft.com/office/drawing/2014/main" id="{7ED988EB-033C-4B0F-99F9-590838BAD6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57985" y="3165497"/>
                <a:ext cx="187067" cy="358211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7" name="Line 73">
              <a:extLst>
                <a:ext uri="{FF2B5EF4-FFF2-40B4-BE49-F238E27FC236}">
                  <a16:creationId xmlns:a16="http://schemas.microsoft.com/office/drawing/2014/main" id="{B389C33E-307D-4C11-9C11-7B75D66D2D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95027" y="906308"/>
              <a:ext cx="0" cy="261408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" name="Line 86">
              <a:extLst>
                <a:ext uri="{FF2B5EF4-FFF2-40B4-BE49-F238E27FC236}">
                  <a16:creationId xmlns:a16="http://schemas.microsoft.com/office/drawing/2014/main" id="{89486823-4A86-4A63-BB92-F172FB372C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5619" y="3270215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" name="Line 87">
              <a:extLst>
                <a:ext uri="{FF2B5EF4-FFF2-40B4-BE49-F238E27FC236}">
                  <a16:creationId xmlns:a16="http://schemas.microsoft.com/office/drawing/2014/main" id="{845252E6-CA70-4B8C-971A-A8456C484D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5619" y="3011507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" name="Line 88">
              <a:extLst>
                <a:ext uri="{FF2B5EF4-FFF2-40B4-BE49-F238E27FC236}">
                  <a16:creationId xmlns:a16="http://schemas.microsoft.com/office/drawing/2014/main" id="{F600B279-6A30-4FBF-A0AA-46881200D5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5619" y="2752799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" name="Line 89">
              <a:extLst>
                <a:ext uri="{FF2B5EF4-FFF2-40B4-BE49-F238E27FC236}">
                  <a16:creationId xmlns:a16="http://schemas.microsoft.com/office/drawing/2014/main" id="{7E535A8D-F7A8-427F-B5D7-CA2AC5B3C5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5619" y="2494091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Line 90">
              <a:extLst>
                <a:ext uri="{FF2B5EF4-FFF2-40B4-BE49-F238E27FC236}">
                  <a16:creationId xmlns:a16="http://schemas.microsoft.com/office/drawing/2014/main" id="{E77ABF44-0F4A-4692-9EE9-CA1C89C59F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5619" y="2242491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Line 91">
              <a:extLst>
                <a:ext uri="{FF2B5EF4-FFF2-40B4-BE49-F238E27FC236}">
                  <a16:creationId xmlns:a16="http://schemas.microsoft.com/office/drawing/2014/main" id="{4900D0ED-79ED-4321-A53C-5576389A28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5619" y="1983784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Line 92">
              <a:extLst>
                <a:ext uri="{FF2B5EF4-FFF2-40B4-BE49-F238E27FC236}">
                  <a16:creationId xmlns:a16="http://schemas.microsoft.com/office/drawing/2014/main" id="{4DDB7C46-8B81-406F-8BF9-8D92089CF3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5619" y="1725076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Line 93">
              <a:extLst>
                <a:ext uri="{FF2B5EF4-FFF2-40B4-BE49-F238E27FC236}">
                  <a16:creationId xmlns:a16="http://schemas.microsoft.com/office/drawing/2014/main" id="{0C2B6B8D-A0FE-442A-9ABB-682A69FFB4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5619" y="1466368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Line 94">
              <a:extLst>
                <a:ext uri="{FF2B5EF4-FFF2-40B4-BE49-F238E27FC236}">
                  <a16:creationId xmlns:a16="http://schemas.microsoft.com/office/drawing/2014/main" id="{D03D80DD-BB79-434B-BA61-E4A5A3C567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5619" y="1216189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" name="Line 95">
              <a:extLst>
                <a:ext uri="{FF2B5EF4-FFF2-40B4-BE49-F238E27FC236}">
                  <a16:creationId xmlns:a16="http://schemas.microsoft.com/office/drawing/2014/main" id="{A322D754-F8F2-4EE3-970D-73A97597B5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5619" y="957481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038C2407-2581-4C30-A608-03E770FC38D4}"/>
                </a:ext>
              </a:extLst>
            </p:cNvPr>
            <p:cNvCxnSpPr/>
            <p:nvPr/>
          </p:nvCxnSpPr>
          <p:spPr>
            <a:xfrm flipV="1">
              <a:off x="1908221" y="3522582"/>
              <a:ext cx="3181670" cy="112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21BA8A5B-3FAF-467B-9A05-2979862B451B}"/>
                </a:ext>
              </a:extLst>
            </p:cNvPr>
            <p:cNvSpPr txBox="1"/>
            <p:nvPr/>
          </p:nvSpPr>
          <p:spPr>
            <a:xfrm rot="16200000">
              <a:off x="1893758" y="3683405"/>
              <a:ext cx="466571" cy="21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MR-9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550B411C-4DC8-4777-958C-2825B9486AAD}"/>
                </a:ext>
              </a:extLst>
            </p:cNvPr>
            <p:cNvSpPr txBox="1"/>
            <p:nvPr/>
          </p:nvSpPr>
          <p:spPr>
            <a:xfrm rot="16200000">
              <a:off x="2108241" y="3676993"/>
              <a:ext cx="455094" cy="21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MRC-5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0C0C0124-AD2D-48C3-85FC-63134BA563F4}"/>
                </a:ext>
              </a:extLst>
            </p:cNvPr>
            <p:cNvSpPr txBox="1"/>
            <p:nvPr/>
          </p:nvSpPr>
          <p:spPr>
            <a:xfrm>
              <a:off x="1549625" y="2905041"/>
              <a:ext cx="350050" cy="192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69AB52BE-84F8-48A4-9FD3-CD2C1A902FBA}"/>
                </a:ext>
              </a:extLst>
            </p:cNvPr>
            <p:cNvSpPr txBox="1"/>
            <p:nvPr/>
          </p:nvSpPr>
          <p:spPr>
            <a:xfrm rot="16200000">
              <a:off x="2320822" y="3684207"/>
              <a:ext cx="468006" cy="21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Ca9-22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7977B316-5A31-4446-B4D8-20C8A09D6E6D}"/>
                </a:ext>
              </a:extLst>
            </p:cNvPr>
            <p:cNvSpPr txBox="1"/>
            <p:nvPr/>
          </p:nvSpPr>
          <p:spPr>
            <a:xfrm rot="16200000">
              <a:off x="2583317" y="3640925"/>
              <a:ext cx="390531" cy="21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FaDu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09904E9F-AD46-403B-9BE8-DD6C07DEF98C}"/>
                </a:ext>
              </a:extLst>
            </p:cNvPr>
            <p:cNvSpPr txBox="1"/>
            <p:nvPr/>
          </p:nvSpPr>
          <p:spPr>
            <a:xfrm rot="16200000">
              <a:off x="2793139" y="3652147"/>
              <a:ext cx="440747" cy="21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SC-2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252ED554-5219-46F4-9780-83536733C2D9}"/>
                </a:ext>
              </a:extLst>
            </p:cNvPr>
            <p:cNvSpPr txBox="1"/>
            <p:nvPr/>
          </p:nvSpPr>
          <p:spPr>
            <a:xfrm rot="16200000">
              <a:off x="3006947" y="3652145"/>
              <a:ext cx="440747" cy="21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SC-3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4B366B15-1D02-4C87-918C-14EA693F19DE}"/>
                </a:ext>
              </a:extLst>
            </p:cNvPr>
            <p:cNvSpPr txBox="1"/>
            <p:nvPr/>
          </p:nvSpPr>
          <p:spPr>
            <a:xfrm rot="16200000">
              <a:off x="3145589" y="3740311"/>
              <a:ext cx="598566" cy="21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SC-3-M3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9E67C1DB-6F60-49C6-B76C-258E90A0DA7D}"/>
                </a:ext>
              </a:extLst>
            </p:cNvPr>
            <p:cNvSpPr txBox="1"/>
            <p:nvPr/>
          </p:nvSpPr>
          <p:spPr>
            <a:xfrm rot="16200000">
              <a:off x="3440502" y="3652147"/>
              <a:ext cx="440747" cy="21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SC-4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329A31E1-225D-4E29-B06C-7094CDD2A4BE}"/>
                </a:ext>
              </a:extLst>
            </p:cNvPr>
            <p:cNvSpPr txBox="1"/>
            <p:nvPr/>
          </p:nvSpPr>
          <p:spPr>
            <a:xfrm rot="16200000">
              <a:off x="3621235" y="3706647"/>
              <a:ext cx="508178" cy="21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KOSC-2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A2214734-7CEF-41A5-B5EF-DBCBEDB711E1}"/>
                </a:ext>
              </a:extLst>
            </p:cNvPr>
            <p:cNvSpPr txBox="1"/>
            <p:nvPr/>
          </p:nvSpPr>
          <p:spPr>
            <a:xfrm rot="16200000">
              <a:off x="3934480" y="3607263"/>
              <a:ext cx="330273" cy="21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Sa3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6D8DA2B4-FE54-465C-8DE6-036250E59B4F}"/>
                </a:ext>
              </a:extLst>
            </p:cNvPr>
            <p:cNvSpPr txBox="1"/>
            <p:nvPr/>
          </p:nvSpPr>
          <p:spPr>
            <a:xfrm rot="16200000">
              <a:off x="4152710" y="3618483"/>
              <a:ext cx="350359" cy="21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SAS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8F9DEF03-7D7A-48F1-815F-8EBBEF33E55E}"/>
                </a:ext>
              </a:extLst>
            </p:cNvPr>
            <p:cNvSpPr txBox="1"/>
            <p:nvPr/>
          </p:nvSpPr>
          <p:spPr>
            <a:xfrm rot="16200000">
              <a:off x="4258938" y="3737106"/>
              <a:ext cx="562698" cy="21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O-1-N-1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EB6511AE-4CF6-4AA1-AAEE-06A567E0BC54}"/>
                </a:ext>
              </a:extLst>
            </p:cNvPr>
            <p:cNvSpPr txBox="1"/>
            <p:nvPr/>
          </p:nvSpPr>
          <p:spPr>
            <a:xfrm rot="16200000">
              <a:off x="4483324" y="3729090"/>
              <a:ext cx="548350" cy="21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O-1-u-1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657441F8-720B-4EDD-9C30-76D81651FEC4}"/>
                </a:ext>
              </a:extLst>
            </p:cNvPr>
            <p:cNvSpPr txBox="1"/>
            <p:nvPr/>
          </p:nvSpPr>
          <p:spPr>
            <a:xfrm>
              <a:off x="1549625" y="2392461"/>
              <a:ext cx="350050" cy="192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DDE7DD32-398E-4E00-9DF7-82B2D2C50E97}"/>
                </a:ext>
              </a:extLst>
            </p:cNvPr>
            <p:cNvSpPr txBox="1"/>
            <p:nvPr/>
          </p:nvSpPr>
          <p:spPr>
            <a:xfrm>
              <a:off x="1549625" y="1881313"/>
              <a:ext cx="350050" cy="192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D868B907-A4C3-4877-8588-D35CBDE32FA7}"/>
                </a:ext>
              </a:extLst>
            </p:cNvPr>
            <p:cNvSpPr txBox="1"/>
            <p:nvPr/>
          </p:nvSpPr>
          <p:spPr>
            <a:xfrm>
              <a:off x="1549625" y="1363969"/>
              <a:ext cx="350050" cy="192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4DC49439-CC51-4005-B106-50FAC8D69D36}"/>
                </a:ext>
              </a:extLst>
            </p:cNvPr>
            <p:cNvSpPr txBox="1"/>
            <p:nvPr/>
          </p:nvSpPr>
          <p:spPr>
            <a:xfrm>
              <a:off x="1549625" y="854974"/>
              <a:ext cx="350050" cy="192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139EA242-E66C-4722-AC63-6EBE645DDEC5}"/>
                </a:ext>
              </a:extLst>
            </p:cNvPr>
            <p:cNvSpPr txBox="1"/>
            <p:nvPr/>
          </p:nvSpPr>
          <p:spPr>
            <a:xfrm>
              <a:off x="1665041" y="3422931"/>
              <a:ext cx="237131" cy="192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C46BA032-788F-4E38-897A-2410641C0AC4}"/>
                </a:ext>
              </a:extLst>
            </p:cNvPr>
            <p:cNvSpPr txBox="1"/>
            <p:nvPr/>
          </p:nvSpPr>
          <p:spPr>
            <a:xfrm rot="16200000">
              <a:off x="310126" y="2118212"/>
              <a:ext cx="2268580" cy="3312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levels of 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iR-31-5p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in HNSCC cell lines</a:t>
              </a:r>
              <a:endPara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IMR-90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1" name="グループ化 90">
            <a:extLst>
              <a:ext uri="{FF2B5EF4-FFF2-40B4-BE49-F238E27FC236}">
                <a16:creationId xmlns:a16="http://schemas.microsoft.com/office/drawing/2014/main" id="{6D71E018-2072-442E-8BCA-4087DE3CAD4B}"/>
              </a:ext>
            </a:extLst>
          </p:cNvPr>
          <p:cNvGrpSpPr/>
          <p:nvPr/>
        </p:nvGrpSpPr>
        <p:grpSpPr>
          <a:xfrm>
            <a:off x="1429764" y="5001401"/>
            <a:ext cx="3814753" cy="3325114"/>
            <a:chOff x="-1" y="4449074"/>
            <a:chExt cx="3814753" cy="3325114"/>
          </a:xfrm>
        </p:grpSpPr>
        <p:sp>
          <p:nvSpPr>
            <p:cNvPr id="92" name="Line 8">
              <a:extLst>
                <a:ext uri="{FF2B5EF4-FFF2-40B4-BE49-F238E27FC236}">
                  <a16:creationId xmlns:a16="http://schemas.microsoft.com/office/drawing/2014/main" id="{243732D6-8EB3-4E7C-B091-3C558B0930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6915" y="6561542"/>
              <a:ext cx="11141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" name="Line 9">
              <a:extLst>
                <a:ext uri="{FF2B5EF4-FFF2-40B4-BE49-F238E27FC236}">
                  <a16:creationId xmlns:a16="http://schemas.microsoft.com/office/drawing/2014/main" id="{41827BDF-DC71-46AF-B74A-8A7C92132D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1935" y="6561542"/>
              <a:ext cx="0" cy="79602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" name="Line 10">
              <a:extLst>
                <a:ext uri="{FF2B5EF4-FFF2-40B4-BE49-F238E27FC236}">
                  <a16:creationId xmlns:a16="http://schemas.microsoft.com/office/drawing/2014/main" id="{D7F9EC5E-DBF4-4653-9C3E-125278E6AD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6915" y="6641144"/>
              <a:ext cx="11141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" name="Line 11">
              <a:extLst>
                <a:ext uri="{FF2B5EF4-FFF2-40B4-BE49-F238E27FC236}">
                  <a16:creationId xmlns:a16="http://schemas.microsoft.com/office/drawing/2014/main" id="{85BC99A5-017A-4307-BC23-CF7CFAB164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2868" y="6232436"/>
              <a:ext cx="110040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" name="Line 12">
              <a:extLst>
                <a:ext uri="{FF2B5EF4-FFF2-40B4-BE49-F238E27FC236}">
                  <a16:creationId xmlns:a16="http://schemas.microsoft.com/office/drawing/2014/main" id="{2B13DF80-01DC-4BD7-86E0-6280EC812E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67887" y="6232436"/>
              <a:ext cx="0" cy="12224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" name="Line 13">
              <a:extLst>
                <a:ext uri="{FF2B5EF4-FFF2-40B4-BE49-F238E27FC236}">
                  <a16:creationId xmlns:a16="http://schemas.microsoft.com/office/drawing/2014/main" id="{9504962C-DF37-4C18-AC28-8BD548D901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2868" y="6354682"/>
              <a:ext cx="110040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" name="Line 14">
              <a:extLst>
                <a:ext uri="{FF2B5EF4-FFF2-40B4-BE49-F238E27FC236}">
                  <a16:creationId xmlns:a16="http://schemas.microsoft.com/office/drawing/2014/main" id="{214C87F4-861D-4B3F-85FC-3D646F0036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34323" y="4978500"/>
              <a:ext cx="11141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" name="Line 15">
              <a:extLst>
                <a:ext uri="{FF2B5EF4-FFF2-40B4-BE49-F238E27FC236}">
                  <a16:creationId xmlns:a16="http://schemas.microsoft.com/office/drawing/2014/main" id="{4F14934E-2F52-47BE-8144-C1E7BA5A75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90718" y="4978500"/>
              <a:ext cx="0" cy="372426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" name="Line 16">
              <a:extLst>
                <a:ext uri="{FF2B5EF4-FFF2-40B4-BE49-F238E27FC236}">
                  <a16:creationId xmlns:a16="http://schemas.microsoft.com/office/drawing/2014/main" id="{806C6200-A05B-4498-806F-98D102EBD8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34323" y="5300126"/>
              <a:ext cx="11141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" name="Line 17">
              <a:extLst>
                <a:ext uri="{FF2B5EF4-FFF2-40B4-BE49-F238E27FC236}">
                  <a16:creationId xmlns:a16="http://schemas.microsoft.com/office/drawing/2014/main" id="{31751391-F76F-4971-A735-2662922C40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50275" y="6943171"/>
              <a:ext cx="11141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" name="Line 18">
              <a:extLst>
                <a:ext uri="{FF2B5EF4-FFF2-40B4-BE49-F238E27FC236}">
                  <a16:creationId xmlns:a16="http://schemas.microsoft.com/office/drawing/2014/main" id="{79CC33E5-2A73-4347-B5D6-F04D5111CB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05295" y="6943171"/>
              <a:ext cx="0" cy="65388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" name="Line 19">
              <a:extLst>
                <a:ext uri="{FF2B5EF4-FFF2-40B4-BE49-F238E27FC236}">
                  <a16:creationId xmlns:a16="http://schemas.microsoft.com/office/drawing/2014/main" id="{40295C2E-80EA-4F75-B71D-8D95701DE3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50275" y="7008559"/>
              <a:ext cx="11141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" name="Line 20">
              <a:extLst>
                <a:ext uri="{FF2B5EF4-FFF2-40B4-BE49-F238E27FC236}">
                  <a16:creationId xmlns:a16="http://schemas.microsoft.com/office/drawing/2014/main" id="{20797A99-BCB4-4CF9-836E-739F10ADA3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73105" y="5049107"/>
              <a:ext cx="11141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" name="Line 21">
              <a:extLst>
                <a:ext uri="{FF2B5EF4-FFF2-40B4-BE49-F238E27FC236}">
                  <a16:creationId xmlns:a16="http://schemas.microsoft.com/office/drawing/2014/main" id="{1D104FD5-367F-410C-BD3D-A892BF11F9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28125" y="5049106"/>
              <a:ext cx="0" cy="1800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" name="Line 23">
              <a:extLst>
                <a:ext uri="{FF2B5EF4-FFF2-40B4-BE49-F238E27FC236}">
                  <a16:creationId xmlns:a16="http://schemas.microsoft.com/office/drawing/2014/main" id="{CAC60880-EFD3-4846-A368-0DBC52B85B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87683" y="5962997"/>
              <a:ext cx="11141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" name="Line 24">
              <a:extLst>
                <a:ext uri="{FF2B5EF4-FFF2-40B4-BE49-F238E27FC236}">
                  <a16:creationId xmlns:a16="http://schemas.microsoft.com/office/drawing/2014/main" id="{8F6B39A0-6AD1-4557-A34E-7F054B2EC3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44078" y="5962997"/>
              <a:ext cx="0" cy="14356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" name="Line 25">
              <a:extLst>
                <a:ext uri="{FF2B5EF4-FFF2-40B4-BE49-F238E27FC236}">
                  <a16:creationId xmlns:a16="http://schemas.microsoft.com/office/drawing/2014/main" id="{259200E9-86D1-4539-B6EF-7B0296AA08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87683" y="6106566"/>
              <a:ext cx="11141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" name="Line 26">
              <a:extLst>
                <a:ext uri="{FF2B5EF4-FFF2-40B4-BE49-F238E27FC236}">
                  <a16:creationId xmlns:a16="http://schemas.microsoft.com/office/drawing/2014/main" id="{B70D89D0-F273-4FAE-ACE3-3B6F97B011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0513" y="5141958"/>
              <a:ext cx="10453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" name="Line 27">
              <a:extLst>
                <a:ext uri="{FF2B5EF4-FFF2-40B4-BE49-F238E27FC236}">
                  <a16:creationId xmlns:a16="http://schemas.microsoft.com/office/drawing/2014/main" id="{4C60C426-8B18-483C-9DF3-4829AED8DC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65533" y="5148308"/>
              <a:ext cx="0" cy="452028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1" name="Line 28">
              <a:extLst>
                <a:ext uri="{FF2B5EF4-FFF2-40B4-BE49-F238E27FC236}">
                  <a16:creationId xmlns:a16="http://schemas.microsoft.com/office/drawing/2014/main" id="{FE49436F-333F-4103-A989-EFF2FA18EC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0513" y="5657486"/>
              <a:ext cx="10453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" name="Line 29">
              <a:extLst>
                <a:ext uri="{FF2B5EF4-FFF2-40B4-BE49-F238E27FC236}">
                  <a16:creationId xmlns:a16="http://schemas.microsoft.com/office/drawing/2014/main" id="{F2325E1E-99A7-4829-BEDB-13B500DC61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6466" y="5182293"/>
              <a:ext cx="11141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" name="Line 30">
              <a:extLst>
                <a:ext uri="{FF2B5EF4-FFF2-40B4-BE49-F238E27FC236}">
                  <a16:creationId xmlns:a16="http://schemas.microsoft.com/office/drawing/2014/main" id="{EE8616C6-E5D5-4296-8B59-E8268AE83A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81486" y="5182293"/>
              <a:ext cx="0" cy="1800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" name="Line 31">
              <a:extLst>
                <a:ext uri="{FF2B5EF4-FFF2-40B4-BE49-F238E27FC236}">
                  <a16:creationId xmlns:a16="http://schemas.microsoft.com/office/drawing/2014/main" id="{0716E284-16E1-4DDA-9D38-9B77DA6708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6466" y="5492595"/>
              <a:ext cx="11141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5" name="Line 32">
              <a:extLst>
                <a:ext uri="{FF2B5EF4-FFF2-40B4-BE49-F238E27FC236}">
                  <a16:creationId xmlns:a16="http://schemas.microsoft.com/office/drawing/2014/main" id="{C1029119-CAFD-42CF-B17B-30DD4CD7C6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47920" y="5518752"/>
              <a:ext cx="10453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6" name="Line 33">
              <a:extLst>
                <a:ext uri="{FF2B5EF4-FFF2-40B4-BE49-F238E27FC236}">
                  <a16:creationId xmlns:a16="http://schemas.microsoft.com/office/drawing/2014/main" id="{2942CCF3-2DF6-4A5A-B504-8E92FC153A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04316" y="5518752"/>
              <a:ext cx="0" cy="17910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7" name="Line 34">
              <a:extLst>
                <a:ext uri="{FF2B5EF4-FFF2-40B4-BE49-F238E27FC236}">
                  <a16:creationId xmlns:a16="http://schemas.microsoft.com/office/drawing/2014/main" id="{140AA581-E10D-414D-98E0-FD70EF0D38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47920" y="5697858"/>
              <a:ext cx="10453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" name="Line 35">
              <a:extLst>
                <a:ext uri="{FF2B5EF4-FFF2-40B4-BE49-F238E27FC236}">
                  <a16:creationId xmlns:a16="http://schemas.microsoft.com/office/drawing/2014/main" id="{902C2129-3810-45D6-8CF6-E5E143A884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63874" y="5257145"/>
              <a:ext cx="11141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" name="Line 36">
              <a:extLst>
                <a:ext uri="{FF2B5EF4-FFF2-40B4-BE49-F238E27FC236}">
                  <a16:creationId xmlns:a16="http://schemas.microsoft.com/office/drawing/2014/main" id="{3FA89067-9963-4C7D-B761-21D8EB61F6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20268" y="5257145"/>
              <a:ext cx="0" cy="2520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" name="Line 38">
              <a:extLst>
                <a:ext uri="{FF2B5EF4-FFF2-40B4-BE49-F238E27FC236}">
                  <a16:creationId xmlns:a16="http://schemas.microsoft.com/office/drawing/2014/main" id="{5865DDC5-4EBF-4E2E-9EBE-E5FCE560DC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86704" y="5294824"/>
              <a:ext cx="10453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" name="Line 39">
              <a:extLst>
                <a:ext uri="{FF2B5EF4-FFF2-40B4-BE49-F238E27FC236}">
                  <a16:creationId xmlns:a16="http://schemas.microsoft.com/office/drawing/2014/main" id="{E490065F-3472-4C7C-AD97-1C79EE58C5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34846" y="5294824"/>
              <a:ext cx="0" cy="2842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2" name="Line 40">
              <a:extLst>
                <a:ext uri="{FF2B5EF4-FFF2-40B4-BE49-F238E27FC236}">
                  <a16:creationId xmlns:a16="http://schemas.microsoft.com/office/drawing/2014/main" id="{F3C3A685-459D-4C42-91AE-3F97BD0663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86704" y="5323253"/>
              <a:ext cx="10453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3" name="Line 41">
              <a:extLst>
                <a:ext uri="{FF2B5EF4-FFF2-40B4-BE49-F238E27FC236}">
                  <a16:creationId xmlns:a16="http://schemas.microsoft.com/office/drawing/2014/main" id="{54F6D672-225B-479E-87A8-545D61D479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02656" y="6256869"/>
              <a:ext cx="110040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" name="Line 42">
              <a:extLst>
                <a:ext uri="{FF2B5EF4-FFF2-40B4-BE49-F238E27FC236}">
                  <a16:creationId xmlns:a16="http://schemas.microsoft.com/office/drawing/2014/main" id="{53506255-4193-45EB-A86A-5A85A398B4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7676" y="6256869"/>
              <a:ext cx="0" cy="143569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" name="Line 43">
              <a:extLst>
                <a:ext uri="{FF2B5EF4-FFF2-40B4-BE49-F238E27FC236}">
                  <a16:creationId xmlns:a16="http://schemas.microsoft.com/office/drawing/2014/main" id="{87EC9937-6FC3-4332-A04F-ACBEFFC869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02656" y="6400438"/>
              <a:ext cx="110040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" name="Line 44">
              <a:extLst>
                <a:ext uri="{FF2B5EF4-FFF2-40B4-BE49-F238E27FC236}">
                  <a16:creationId xmlns:a16="http://schemas.microsoft.com/office/drawing/2014/main" id="{7A893743-36BB-42FE-8D86-2BBE32A01A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17233" y="6576212"/>
              <a:ext cx="11141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7" name="Line 45">
              <a:extLst>
                <a:ext uri="{FF2B5EF4-FFF2-40B4-BE49-F238E27FC236}">
                  <a16:creationId xmlns:a16="http://schemas.microsoft.com/office/drawing/2014/main" id="{400E821B-BA14-443F-8CFD-D6BE047C19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73629" y="6576212"/>
              <a:ext cx="0" cy="3553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8" name="Line 46">
              <a:extLst>
                <a:ext uri="{FF2B5EF4-FFF2-40B4-BE49-F238E27FC236}">
                  <a16:creationId xmlns:a16="http://schemas.microsoft.com/office/drawing/2014/main" id="{B7859655-275C-4146-A7B2-8A80501406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17233" y="6611748"/>
              <a:ext cx="11141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" name="Rectangle 48">
              <a:extLst>
                <a:ext uri="{FF2B5EF4-FFF2-40B4-BE49-F238E27FC236}">
                  <a16:creationId xmlns:a16="http://schemas.microsoft.com/office/drawing/2014/main" id="{99F8FFB6-7098-4808-A005-D1BF5DC065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2528" y="6605608"/>
              <a:ext cx="180190" cy="508887"/>
            </a:xfrm>
            <a:prstGeom prst="rect">
              <a:avLst/>
            </a:prstGeom>
            <a:solidFill>
              <a:schemeClr val="tx1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" name="Rectangle 50">
              <a:extLst>
                <a:ext uri="{FF2B5EF4-FFF2-40B4-BE49-F238E27FC236}">
                  <a16:creationId xmlns:a16="http://schemas.microsoft.com/office/drawing/2014/main" id="{7D7836AC-26B6-47ED-B2B4-DBF835DB69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7105" y="6292850"/>
              <a:ext cx="188443" cy="824958"/>
            </a:xfrm>
            <a:prstGeom prst="rect">
              <a:avLst/>
            </a:prstGeom>
            <a:solidFill>
              <a:schemeClr val="tx1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" name="Rectangle 52">
              <a:extLst>
                <a:ext uri="{FF2B5EF4-FFF2-40B4-BE49-F238E27FC236}">
                  <a16:creationId xmlns:a16="http://schemas.microsoft.com/office/drawing/2014/main" id="{44AFF338-DD60-4F97-AEC9-8611CA957C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3058" y="5003800"/>
              <a:ext cx="187067" cy="211400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" name="Rectangle 54">
              <a:extLst>
                <a:ext uri="{FF2B5EF4-FFF2-40B4-BE49-F238E27FC236}">
                  <a16:creationId xmlns:a16="http://schemas.microsoft.com/office/drawing/2014/main" id="{564D7851-7BFA-406E-8545-695BF12448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15888" y="6972300"/>
              <a:ext cx="187067" cy="14550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" name="Rectangle 56">
              <a:extLst>
                <a:ext uri="{FF2B5EF4-FFF2-40B4-BE49-F238E27FC236}">
                  <a16:creationId xmlns:a16="http://schemas.microsoft.com/office/drawing/2014/main" id="{C9E51C36-3949-4480-B8D0-641D0A4505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0465" y="5207000"/>
              <a:ext cx="188443" cy="191080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" name="Rectangle 58">
              <a:extLst>
                <a:ext uri="{FF2B5EF4-FFF2-40B4-BE49-F238E27FC236}">
                  <a16:creationId xmlns:a16="http://schemas.microsoft.com/office/drawing/2014/main" id="{7B9EA2B1-8AFC-474F-AADD-BDF9F7950C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3296" y="6083301"/>
              <a:ext cx="188443" cy="103450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" name="Rectangle 60">
              <a:extLst>
                <a:ext uri="{FF2B5EF4-FFF2-40B4-BE49-F238E27FC236}">
                  <a16:creationId xmlns:a16="http://schemas.microsoft.com/office/drawing/2014/main" id="{EF3692D9-A952-4E14-B476-541C0B68FE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9248" y="5346701"/>
              <a:ext cx="187067" cy="177110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6" name="Rectangle 62">
              <a:extLst>
                <a:ext uri="{FF2B5EF4-FFF2-40B4-BE49-F238E27FC236}">
                  <a16:creationId xmlns:a16="http://schemas.microsoft.com/office/drawing/2014/main" id="{D73BDF2D-1934-4176-8DB4-8E9EF0D515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0703" y="5219700"/>
              <a:ext cx="181565" cy="189810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7" name="Rectangle 64">
              <a:extLst>
                <a:ext uri="{FF2B5EF4-FFF2-40B4-BE49-F238E27FC236}">
                  <a16:creationId xmlns:a16="http://schemas.microsoft.com/office/drawing/2014/main" id="{5514DE05-D495-4714-A083-3EFE5C0D32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6656" y="5562601"/>
              <a:ext cx="188443" cy="155520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" name="Rectangle 66">
              <a:extLst>
                <a:ext uri="{FF2B5EF4-FFF2-40B4-BE49-F238E27FC236}">
                  <a16:creationId xmlns:a16="http://schemas.microsoft.com/office/drawing/2014/main" id="{07279218-72C2-451D-8482-1292B005C9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9486" y="5480051"/>
              <a:ext cx="180190" cy="163775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" name="Rectangle 68">
              <a:extLst>
                <a:ext uri="{FF2B5EF4-FFF2-40B4-BE49-F238E27FC236}">
                  <a16:creationId xmlns:a16="http://schemas.microsoft.com/office/drawing/2014/main" id="{0CF3B186-4A57-4BBB-B039-9324391AC1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5439" y="5321300"/>
              <a:ext cx="187067" cy="179650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" name="Rectangle 70">
              <a:extLst>
                <a:ext uri="{FF2B5EF4-FFF2-40B4-BE49-F238E27FC236}">
                  <a16:creationId xmlns:a16="http://schemas.microsoft.com/office/drawing/2014/main" id="{61327426-60A5-4255-A89C-AB546BFA44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6893" y="6305550"/>
              <a:ext cx="181565" cy="81225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" name="Rectangle 72">
              <a:extLst>
                <a:ext uri="{FF2B5EF4-FFF2-40B4-BE49-F238E27FC236}">
                  <a16:creationId xmlns:a16="http://schemas.microsoft.com/office/drawing/2014/main" id="{95A6A2CC-61B6-44D9-BEC3-FF22ACE6E3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2846" y="6604001"/>
              <a:ext cx="187067" cy="51380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2" name="Line 73">
              <a:extLst>
                <a:ext uri="{FF2B5EF4-FFF2-40B4-BE49-F238E27FC236}">
                  <a16:creationId xmlns:a16="http://schemas.microsoft.com/office/drawing/2014/main" id="{6D69B61B-5FBD-486F-BEFC-C02421DF91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9888" y="4500408"/>
              <a:ext cx="0" cy="261408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3" name="Line 86">
              <a:extLst>
                <a:ext uri="{FF2B5EF4-FFF2-40B4-BE49-F238E27FC236}">
                  <a16:creationId xmlns:a16="http://schemas.microsoft.com/office/drawing/2014/main" id="{FA25B281-B462-4C41-B398-7F21576F61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0480" y="6864315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4" name="Line 87">
              <a:extLst>
                <a:ext uri="{FF2B5EF4-FFF2-40B4-BE49-F238E27FC236}">
                  <a16:creationId xmlns:a16="http://schemas.microsoft.com/office/drawing/2014/main" id="{9CA64A86-82D4-4C35-885F-D9B7867DAB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0480" y="6605607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" name="Line 88">
              <a:extLst>
                <a:ext uri="{FF2B5EF4-FFF2-40B4-BE49-F238E27FC236}">
                  <a16:creationId xmlns:a16="http://schemas.microsoft.com/office/drawing/2014/main" id="{745566D4-8CDC-4D1A-83C7-7EA3431BF1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0480" y="6346899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" name="Line 89">
              <a:extLst>
                <a:ext uri="{FF2B5EF4-FFF2-40B4-BE49-F238E27FC236}">
                  <a16:creationId xmlns:a16="http://schemas.microsoft.com/office/drawing/2014/main" id="{7EDD6CDB-2638-4108-A8E2-D666E6AC3C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0480" y="6088191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7" name="Line 90">
              <a:extLst>
                <a:ext uri="{FF2B5EF4-FFF2-40B4-BE49-F238E27FC236}">
                  <a16:creationId xmlns:a16="http://schemas.microsoft.com/office/drawing/2014/main" id="{8FBB350F-9947-49CA-AD7E-2B95481BC7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0480" y="5836591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8" name="Line 91">
              <a:extLst>
                <a:ext uri="{FF2B5EF4-FFF2-40B4-BE49-F238E27FC236}">
                  <a16:creationId xmlns:a16="http://schemas.microsoft.com/office/drawing/2014/main" id="{8C23479F-80A3-470C-8FA7-AC04A2FD1B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0480" y="5577884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9" name="Line 92">
              <a:extLst>
                <a:ext uri="{FF2B5EF4-FFF2-40B4-BE49-F238E27FC236}">
                  <a16:creationId xmlns:a16="http://schemas.microsoft.com/office/drawing/2014/main" id="{1ED9CA5B-5599-4AB0-AAD6-022A903C8F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0480" y="5319176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0" name="Line 93">
              <a:extLst>
                <a:ext uri="{FF2B5EF4-FFF2-40B4-BE49-F238E27FC236}">
                  <a16:creationId xmlns:a16="http://schemas.microsoft.com/office/drawing/2014/main" id="{7A05E953-ED93-4955-8500-55C96F2561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0480" y="5060468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1" name="Line 94">
              <a:extLst>
                <a:ext uri="{FF2B5EF4-FFF2-40B4-BE49-F238E27FC236}">
                  <a16:creationId xmlns:a16="http://schemas.microsoft.com/office/drawing/2014/main" id="{35AC939D-629B-49BF-A0B9-BA8EE23126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0480" y="4810289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2" name="Line 95">
              <a:extLst>
                <a:ext uri="{FF2B5EF4-FFF2-40B4-BE49-F238E27FC236}">
                  <a16:creationId xmlns:a16="http://schemas.microsoft.com/office/drawing/2014/main" id="{A8A83738-7291-456D-AEF8-06E68F6988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0480" y="4551581"/>
              <a:ext cx="89408" cy="0"/>
            </a:xfrm>
            <a:prstGeom prst="line">
              <a:avLst/>
            </a:prstGeom>
            <a:noFill/>
            <a:ln w="12700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cxnSp>
          <p:nvCxnSpPr>
            <p:cNvPr id="153" name="直線コネクタ 152">
              <a:extLst>
                <a:ext uri="{FF2B5EF4-FFF2-40B4-BE49-F238E27FC236}">
                  <a16:creationId xmlns:a16="http://schemas.microsoft.com/office/drawing/2014/main" id="{75E5548D-BFC1-41DF-9C97-B110938A38A3}"/>
                </a:ext>
              </a:extLst>
            </p:cNvPr>
            <p:cNvCxnSpPr/>
            <p:nvPr/>
          </p:nvCxnSpPr>
          <p:spPr>
            <a:xfrm flipV="1">
              <a:off x="633082" y="7116682"/>
              <a:ext cx="3181670" cy="112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E031A5ED-F45F-415C-B36A-A9E3452D0D6A}"/>
                </a:ext>
              </a:extLst>
            </p:cNvPr>
            <p:cNvSpPr txBox="1"/>
            <p:nvPr/>
          </p:nvSpPr>
          <p:spPr>
            <a:xfrm rot="16200000">
              <a:off x="591256" y="7275174"/>
              <a:ext cx="5212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MR-9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9FE3238B-DB88-4CC4-A090-0BED8E786DCA}"/>
                </a:ext>
              </a:extLst>
            </p:cNvPr>
            <p:cNvSpPr txBox="1"/>
            <p:nvPr/>
          </p:nvSpPr>
          <p:spPr>
            <a:xfrm rot="16200000">
              <a:off x="806412" y="7268762"/>
              <a:ext cx="50847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MRC-5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062DABCD-E354-44C8-8FC8-5A58E8F8458B}"/>
                </a:ext>
              </a:extLst>
            </p:cNvPr>
            <p:cNvSpPr txBox="1"/>
            <p:nvPr/>
          </p:nvSpPr>
          <p:spPr>
            <a:xfrm>
              <a:off x="274486" y="6499141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テキスト ボックス 156">
              <a:extLst>
                <a:ext uri="{FF2B5EF4-FFF2-40B4-BE49-F238E27FC236}">
                  <a16:creationId xmlns:a16="http://schemas.microsoft.com/office/drawing/2014/main" id="{B6373087-2553-46A0-883A-E1BDE68B06FB}"/>
                </a:ext>
              </a:extLst>
            </p:cNvPr>
            <p:cNvSpPr txBox="1"/>
            <p:nvPr/>
          </p:nvSpPr>
          <p:spPr>
            <a:xfrm rot="16200000">
              <a:off x="1018236" y="7275976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Ca9-22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D9DE4767-40FA-4F51-8A63-5C1B655B6B78}"/>
                </a:ext>
              </a:extLst>
            </p:cNvPr>
            <p:cNvSpPr txBox="1"/>
            <p:nvPr/>
          </p:nvSpPr>
          <p:spPr>
            <a:xfrm rot="16200000">
              <a:off x="1285274" y="7232695"/>
              <a:ext cx="4363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FaDu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88FCCFA8-08B3-435B-B0AB-7D667C2D8175}"/>
                </a:ext>
              </a:extLst>
            </p:cNvPr>
            <p:cNvSpPr txBox="1"/>
            <p:nvPr/>
          </p:nvSpPr>
          <p:spPr>
            <a:xfrm rot="16200000">
              <a:off x="1492152" y="7243916"/>
              <a:ext cx="4924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SC-2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82E422FC-779A-41CB-A78D-B987BF40D9AF}"/>
                </a:ext>
              </a:extLst>
            </p:cNvPr>
            <p:cNvSpPr txBox="1"/>
            <p:nvPr/>
          </p:nvSpPr>
          <p:spPr>
            <a:xfrm rot="16200000">
              <a:off x="1705960" y="7243915"/>
              <a:ext cx="4924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SC-3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F13D8ED6-1CFD-4AAA-9660-87A29A1F891F}"/>
                </a:ext>
              </a:extLst>
            </p:cNvPr>
            <p:cNvSpPr txBox="1"/>
            <p:nvPr/>
          </p:nvSpPr>
          <p:spPr>
            <a:xfrm rot="16200000">
              <a:off x="1835346" y="7332080"/>
              <a:ext cx="66877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SC-3-M3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D673B701-9EDC-4204-93E0-C6B1FD2734FF}"/>
                </a:ext>
              </a:extLst>
            </p:cNvPr>
            <p:cNvSpPr txBox="1"/>
            <p:nvPr/>
          </p:nvSpPr>
          <p:spPr>
            <a:xfrm rot="16200000">
              <a:off x="2139516" y="7243916"/>
              <a:ext cx="4924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SC-4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D37A0F59-24CB-4883-8F65-24749CA41C67}"/>
                </a:ext>
              </a:extLst>
            </p:cNvPr>
            <p:cNvSpPr txBox="1"/>
            <p:nvPr/>
          </p:nvSpPr>
          <p:spPr>
            <a:xfrm rot="16200000">
              <a:off x="2316293" y="7298416"/>
              <a:ext cx="5677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KOSC-2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テキスト ボックス 163">
              <a:extLst>
                <a:ext uri="{FF2B5EF4-FFF2-40B4-BE49-F238E27FC236}">
                  <a16:creationId xmlns:a16="http://schemas.microsoft.com/office/drawing/2014/main" id="{A8E27B5E-9D05-44E8-86C3-C0375C065D08}"/>
                </a:ext>
              </a:extLst>
            </p:cNvPr>
            <p:cNvSpPr txBox="1"/>
            <p:nvPr/>
          </p:nvSpPr>
          <p:spPr>
            <a:xfrm rot="16200000">
              <a:off x="2639972" y="7199032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Sa3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32857C30-C3DC-4602-A9D0-B1500BDB7EA7}"/>
                </a:ext>
              </a:extLst>
            </p:cNvPr>
            <p:cNvSpPr txBox="1"/>
            <p:nvPr/>
          </p:nvSpPr>
          <p:spPr>
            <a:xfrm rot="16200000">
              <a:off x="2857024" y="7210252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SAS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テキスト ボックス 165">
              <a:extLst>
                <a:ext uri="{FF2B5EF4-FFF2-40B4-BE49-F238E27FC236}">
                  <a16:creationId xmlns:a16="http://schemas.microsoft.com/office/drawing/2014/main" id="{8AF7E885-9496-4E08-9852-995FF0165C12}"/>
                </a:ext>
              </a:extLst>
            </p:cNvPr>
            <p:cNvSpPr txBox="1"/>
            <p:nvPr/>
          </p:nvSpPr>
          <p:spPr>
            <a:xfrm rot="16200000">
              <a:off x="2950799" y="7328875"/>
              <a:ext cx="6286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O-1-N-1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57526059-221E-45C7-95E9-728532F4E20B}"/>
                </a:ext>
              </a:extLst>
            </p:cNvPr>
            <p:cNvSpPr txBox="1"/>
            <p:nvPr/>
          </p:nvSpPr>
          <p:spPr>
            <a:xfrm rot="16200000">
              <a:off x="3176027" y="7320859"/>
              <a:ext cx="6126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O-1-u-1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6385BC75-6E9D-45FE-99EA-7F9C92F46CFC}"/>
                </a:ext>
              </a:extLst>
            </p:cNvPr>
            <p:cNvSpPr txBox="1"/>
            <p:nvPr/>
          </p:nvSpPr>
          <p:spPr>
            <a:xfrm>
              <a:off x="274486" y="5986561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A8F3D6C0-3896-456C-BF68-117D3C9C0B6A}"/>
                </a:ext>
              </a:extLst>
            </p:cNvPr>
            <p:cNvSpPr txBox="1"/>
            <p:nvPr/>
          </p:nvSpPr>
          <p:spPr>
            <a:xfrm>
              <a:off x="274486" y="5475413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テキスト ボックス 169">
              <a:extLst>
                <a:ext uri="{FF2B5EF4-FFF2-40B4-BE49-F238E27FC236}">
                  <a16:creationId xmlns:a16="http://schemas.microsoft.com/office/drawing/2014/main" id="{1C97E768-2CE3-4467-A041-82F4B3362279}"/>
                </a:ext>
              </a:extLst>
            </p:cNvPr>
            <p:cNvSpPr txBox="1"/>
            <p:nvPr/>
          </p:nvSpPr>
          <p:spPr>
            <a:xfrm>
              <a:off x="274486" y="4958069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A938161A-1DAF-45B6-8139-734D7658B4FB}"/>
                </a:ext>
              </a:extLst>
            </p:cNvPr>
            <p:cNvSpPr txBox="1"/>
            <p:nvPr/>
          </p:nvSpPr>
          <p:spPr>
            <a:xfrm>
              <a:off x="274486" y="4449074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テキスト ボックス 171">
              <a:extLst>
                <a:ext uri="{FF2B5EF4-FFF2-40B4-BE49-F238E27FC236}">
                  <a16:creationId xmlns:a16="http://schemas.microsoft.com/office/drawing/2014/main" id="{3CDADFF0-D8AA-471C-A5A4-64CE6C213C12}"/>
                </a:ext>
              </a:extLst>
            </p:cNvPr>
            <p:cNvSpPr txBox="1"/>
            <p:nvPr/>
          </p:nvSpPr>
          <p:spPr>
            <a:xfrm>
              <a:off x="389902" y="701703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テキスト ボックス 172">
              <a:extLst>
                <a:ext uri="{FF2B5EF4-FFF2-40B4-BE49-F238E27FC236}">
                  <a16:creationId xmlns:a16="http://schemas.microsoft.com/office/drawing/2014/main" id="{181CB9F8-2656-4BC2-A6D8-A586DFAF5181}"/>
                </a:ext>
              </a:extLst>
            </p:cNvPr>
            <p:cNvSpPr txBox="1"/>
            <p:nvPr/>
          </p:nvSpPr>
          <p:spPr>
            <a:xfrm rot="16200000">
              <a:off x="-1098058" y="5708650"/>
              <a:ext cx="253466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levels of 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iR-31-3p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in HNSCC cell lines</a:t>
              </a:r>
              <a:endPara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IMR-90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01AF8C0C-AA8F-4B05-ABF6-13659FA86364}"/>
              </a:ext>
            </a:extLst>
          </p:cNvPr>
          <p:cNvSpPr txBox="1"/>
          <p:nvPr/>
        </p:nvSpPr>
        <p:spPr>
          <a:xfrm>
            <a:off x="81985" y="9144299"/>
            <a:ext cx="6815367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igure S1 Up-regulation of </a:t>
            </a: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miR-31-5p/-3p 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 HNSCC cell lines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o investigate the status of the </a:t>
            </a: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miR-31-5p/-3p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expression as a cancer-related miRNAs, we  conducted 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PCR  analysis with 11 HNSCC-derived cell lines and 2 Fibroblast cell lines(IMR-90 and MRC-5). </a:t>
            </a: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miR-31-5p/-3p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expression was up-regulated significantly in HNSCC-derived cell lines other than 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FaDu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and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O-1-u-1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ompared with the IMR-90.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Rectangle 185">
            <a:extLst>
              <a:ext uri="{FF2B5EF4-FFF2-40B4-BE49-F238E27FC236}">
                <a16:creationId xmlns:a16="http://schemas.microsoft.com/office/drawing/2014/main" id="{74375C0C-C811-4032-A3E1-2CF11EA569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54072" y="784771"/>
            <a:ext cx="20037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Rectangle 185">
            <a:extLst>
              <a:ext uri="{FF2B5EF4-FFF2-40B4-BE49-F238E27FC236}">
                <a16:creationId xmlns:a16="http://schemas.microsoft.com/office/drawing/2014/main" id="{23236AA1-274A-486F-9B90-CA4C6EA96A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19667" y="4812952"/>
            <a:ext cx="20037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13932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59D1918-C192-4C41-A0B3-802CE8A34AD5}"/>
              </a:ext>
            </a:extLst>
          </p:cNvPr>
          <p:cNvSpPr txBox="1"/>
          <p:nvPr/>
        </p:nvSpPr>
        <p:spPr>
          <a:xfrm>
            <a:off x="149730" y="162206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EC64211A-44EE-43EF-A34B-F6EBF3E2A92B}"/>
              </a:ext>
            </a:extLst>
          </p:cNvPr>
          <p:cNvGrpSpPr/>
          <p:nvPr/>
        </p:nvGrpSpPr>
        <p:grpSpPr>
          <a:xfrm>
            <a:off x="3486201" y="928446"/>
            <a:ext cx="1788820" cy="3327796"/>
            <a:chOff x="3533229" y="851344"/>
            <a:chExt cx="1703693" cy="3017744"/>
          </a:xfrm>
        </p:grpSpPr>
        <p:sp>
          <p:nvSpPr>
            <p:cNvPr id="6" name="Line 465">
              <a:extLst>
                <a:ext uri="{FF2B5EF4-FFF2-40B4-BE49-F238E27FC236}">
                  <a16:creationId xmlns:a16="http://schemas.microsoft.com/office/drawing/2014/main" id="{1E21B611-5CF2-4BF2-8406-1E08875AFD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18618" y="1220044"/>
              <a:ext cx="0" cy="1584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anchor="ctr"/>
            <a:lstStyle/>
            <a:p>
              <a:endParaRPr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tangle 175">
              <a:extLst>
                <a:ext uri="{FF2B5EF4-FFF2-40B4-BE49-F238E27FC236}">
                  <a16:creationId xmlns:a16="http://schemas.microsoft.com/office/drawing/2014/main" id="{DBC8AA0D-F2B6-4633-BD1D-BFA29A3D5E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3701" y="2754549"/>
              <a:ext cx="54962" cy="111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Line 261">
              <a:extLst>
                <a:ext uri="{FF2B5EF4-FFF2-40B4-BE49-F238E27FC236}">
                  <a16:creationId xmlns:a16="http://schemas.microsoft.com/office/drawing/2014/main" id="{397D138D-3FEB-4201-8C0A-D7AE17AF27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65715" y="2560704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Line 263">
              <a:extLst>
                <a:ext uri="{FF2B5EF4-FFF2-40B4-BE49-F238E27FC236}">
                  <a16:creationId xmlns:a16="http://schemas.microsoft.com/office/drawing/2014/main" id="{504F8FB4-48B4-4FC7-8E89-C190E12773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65715" y="2320992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Line 265">
              <a:extLst>
                <a:ext uri="{FF2B5EF4-FFF2-40B4-BE49-F238E27FC236}">
                  <a16:creationId xmlns:a16="http://schemas.microsoft.com/office/drawing/2014/main" id="{C1AD9324-4B02-4099-ACC1-881F868576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65715" y="2081280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Line 267">
              <a:extLst>
                <a:ext uri="{FF2B5EF4-FFF2-40B4-BE49-F238E27FC236}">
                  <a16:creationId xmlns:a16="http://schemas.microsoft.com/office/drawing/2014/main" id="{E7A5EE4D-0757-46A0-91E1-3BED02A4FD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65715" y="1841568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Line 269">
              <a:extLst>
                <a:ext uri="{FF2B5EF4-FFF2-40B4-BE49-F238E27FC236}">
                  <a16:creationId xmlns:a16="http://schemas.microsoft.com/office/drawing/2014/main" id="{774F1B18-D5C9-4738-9F70-A41BE7E3A8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65715" y="1601856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Line 271">
              <a:extLst>
                <a:ext uri="{FF2B5EF4-FFF2-40B4-BE49-F238E27FC236}">
                  <a16:creationId xmlns:a16="http://schemas.microsoft.com/office/drawing/2014/main" id="{3ED25503-3FBE-4BD6-BC95-ADFD6F23E7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65715" y="1366401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175">
              <a:extLst>
                <a:ext uri="{FF2B5EF4-FFF2-40B4-BE49-F238E27FC236}">
                  <a16:creationId xmlns:a16="http://schemas.microsoft.com/office/drawing/2014/main" id="{2432B3ED-B672-4314-B8BF-84764072B8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8738" y="2508841"/>
              <a:ext cx="109925" cy="111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tangle 177">
              <a:extLst>
                <a:ext uri="{FF2B5EF4-FFF2-40B4-BE49-F238E27FC236}">
                  <a16:creationId xmlns:a16="http://schemas.microsoft.com/office/drawing/2014/main" id="{C6D69684-07D5-4197-B49C-410C38721C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8738" y="2268865"/>
              <a:ext cx="109925" cy="111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angle 179">
              <a:extLst>
                <a:ext uri="{FF2B5EF4-FFF2-40B4-BE49-F238E27FC236}">
                  <a16:creationId xmlns:a16="http://schemas.microsoft.com/office/drawing/2014/main" id="{2E729A11-9C07-4308-AE39-5B836CCD62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8738" y="2028889"/>
              <a:ext cx="109925" cy="111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181">
              <a:extLst>
                <a:ext uri="{FF2B5EF4-FFF2-40B4-BE49-F238E27FC236}">
                  <a16:creationId xmlns:a16="http://schemas.microsoft.com/office/drawing/2014/main" id="{76A33957-EADC-4C83-9D4B-952FA858C0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8738" y="1788913"/>
              <a:ext cx="109925" cy="111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ctangle 183">
              <a:extLst>
                <a:ext uri="{FF2B5EF4-FFF2-40B4-BE49-F238E27FC236}">
                  <a16:creationId xmlns:a16="http://schemas.microsoft.com/office/drawing/2014/main" id="{D060D33C-DA3D-4AA8-B108-3971301062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3776" y="1548937"/>
              <a:ext cx="164886" cy="111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ectangle 185">
              <a:extLst>
                <a:ext uri="{FF2B5EF4-FFF2-40B4-BE49-F238E27FC236}">
                  <a16:creationId xmlns:a16="http://schemas.microsoft.com/office/drawing/2014/main" id="{45ED2D47-F4DE-4DDE-B1E9-836F07294C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3776" y="1308961"/>
              <a:ext cx="164886" cy="111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ctangle 185">
              <a:extLst>
                <a:ext uri="{FF2B5EF4-FFF2-40B4-BE49-F238E27FC236}">
                  <a16:creationId xmlns:a16="http://schemas.microsoft.com/office/drawing/2014/main" id="{9D766517-9BD9-47EE-8E8B-04C6E32A63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7516" y="1135137"/>
              <a:ext cx="151146" cy="111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%)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Line 152">
              <a:extLst>
                <a:ext uri="{FF2B5EF4-FFF2-40B4-BE49-F238E27FC236}">
                  <a16:creationId xmlns:a16="http://schemas.microsoft.com/office/drawing/2014/main" id="{E8679F26-E6CA-4BBE-B9C1-D749E72503B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60588" y="2202811"/>
              <a:ext cx="0" cy="72000"/>
            </a:xfrm>
            <a:prstGeom prst="lin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Rectangle 69">
              <a:extLst>
                <a:ext uri="{FF2B5EF4-FFF2-40B4-BE49-F238E27FC236}">
                  <a16:creationId xmlns:a16="http://schemas.microsoft.com/office/drawing/2014/main" id="{C6873564-B0D4-4A9B-8C35-750F2D7492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60675" y="2219325"/>
              <a:ext cx="199827" cy="584083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B28308D4-E23E-4928-BE1B-0BA886DC8A41}"/>
                </a:ext>
              </a:extLst>
            </p:cNvPr>
            <p:cNvGrpSpPr/>
            <p:nvPr/>
          </p:nvGrpSpPr>
          <p:grpSpPr>
            <a:xfrm>
              <a:off x="4225901" y="1564956"/>
              <a:ext cx="99913" cy="108000"/>
              <a:chOff x="2097265" y="1568012"/>
              <a:chExt cx="99913" cy="108000"/>
            </a:xfrm>
          </p:grpSpPr>
          <p:sp>
            <p:nvSpPr>
              <p:cNvPr id="44" name="Line 140">
                <a:extLst>
                  <a:ext uri="{FF2B5EF4-FFF2-40B4-BE49-F238E27FC236}">
                    <a16:creationId xmlns:a16="http://schemas.microsoft.com/office/drawing/2014/main" id="{1491E92D-0E2B-4F8D-9833-0D82904085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7221" y="1568012"/>
                <a:ext cx="0" cy="108000"/>
              </a:xfrm>
              <a:prstGeom prst="lin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Line 141">
                <a:extLst>
                  <a:ext uri="{FF2B5EF4-FFF2-40B4-BE49-F238E27FC236}">
                    <a16:creationId xmlns:a16="http://schemas.microsoft.com/office/drawing/2014/main" id="{7CFEDD63-7EAF-4C07-94DF-4F5029E7BB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97265" y="1568013"/>
                <a:ext cx="99913" cy="0"/>
              </a:xfrm>
              <a:prstGeom prst="lin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" name="Rectangle 142">
              <a:extLst>
                <a:ext uri="{FF2B5EF4-FFF2-40B4-BE49-F238E27FC236}">
                  <a16:creationId xmlns:a16="http://schemas.microsoft.com/office/drawing/2014/main" id="{107D45DB-3AF5-4D97-8333-F042116F06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5944" y="1604744"/>
              <a:ext cx="199827" cy="119866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5" name="グループ化 24">
              <a:extLst>
                <a:ext uri="{FF2B5EF4-FFF2-40B4-BE49-F238E27FC236}">
                  <a16:creationId xmlns:a16="http://schemas.microsoft.com/office/drawing/2014/main" id="{CFAC782A-1DCE-47B5-A96C-792CCFD04857}"/>
                </a:ext>
              </a:extLst>
            </p:cNvPr>
            <p:cNvGrpSpPr/>
            <p:nvPr/>
          </p:nvGrpSpPr>
          <p:grpSpPr>
            <a:xfrm>
              <a:off x="4487477" y="1610515"/>
              <a:ext cx="99914" cy="144000"/>
              <a:chOff x="4487477" y="1739104"/>
              <a:chExt cx="99914" cy="144000"/>
            </a:xfrm>
          </p:grpSpPr>
          <p:sp>
            <p:nvSpPr>
              <p:cNvPr id="42" name="Line 146">
                <a:extLst>
                  <a:ext uri="{FF2B5EF4-FFF2-40B4-BE49-F238E27FC236}">
                    <a16:creationId xmlns:a16="http://schemas.microsoft.com/office/drawing/2014/main" id="{08396F51-D1F9-462F-951E-E45C4B4CBC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37434" y="1739104"/>
                <a:ext cx="0" cy="144000"/>
              </a:xfrm>
              <a:prstGeom prst="line">
                <a:avLst/>
              </a:prstGeom>
              <a:solidFill>
                <a:schemeClr val="bg1">
                  <a:lumMod val="95000"/>
                </a:schemeClr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Line 147">
                <a:extLst>
                  <a:ext uri="{FF2B5EF4-FFF2-40B4-BE49-F238E27FC236}">
                    <a16:creationId xmlns:a16="http://schemas.microsoft.com/office/drawing/2014/main" id="{1EEF132B-0865-42BB-BF71-7930A7ADCF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87477" y="1743100"/>
                <a:ext cx="99914" cy="0"/>
              </a:xfrm>
              <a:prstGeom prst="line">
                <a:avLst/>
              </a:prstGeom>
              <a:solidFill>
                <a:schemeClr val="bg1">
                  <a:lumMod val="95000"/>
                </a:schemeClr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6" name="Rectangle 148">
              <a:extLst>
                <a:ext uri="{FF2B5EF4-FFF2-40B4-BE49-F238E27FC236}">
                  <a16:creationId xmlns:a16="http://schemas.microsoft.com/office/drawing/2014/main" id="{590CE6EC-BAE1-463D-8BF7-9842E1DFFC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37521" y="1638300"/>
              <a:ext cx="199827" cy="116510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Line 152">
              <a:extLst>
                <a:ext uri="{FF2B5EF4-FFF2-40B4-BE49-F238E27FC236}">
                  <a16:creationId xmlns:a16="http://schemas.microsoft.com/office/drawing/2014/main" id="{087957AE-34FA-48F0-BB18-F6206E3009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94248" y="1851723"/>
              <a:ext cx="0" cy="108000"/>
            </a:xfrm>
            <a:prstGeom prst="lin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Line 153">
              <a:extLst>
                <a:ext uri="{FF2B5EF4-FFF2-40B4-BE49-F238E27FC236}">
                  <a16:creationId xmlns:a16="http://schemas.microsoft.com/office/drawing/2014/main" id="{62C87533-6E2C-4501-9158-B2058EEA7F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44291" y="1856645"/>
              <a:ext cx="99914" cy="0"/>
            </a:xfrm>
            <a:prstGeom prst="lin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Rectangle 154">
              <a:extLst>
                <a:ext uri="{FF2B5EF4-FFF2-40B4-BE49-F238E27FC236}">
                  <a16:creationId xmlns:a16="http://schemas.microsoft.com/office/drawing/2014/main" id="{2892DFC2-0ADB-4AB3-8F1D-64FAE3D71F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99098" y="1876425"/>
              <a:ext cx="199827" cy="926983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Line 153">
              <a:extLst>
                <a:ext uri="{FF2B5EF4-FFF2-40B4-BE49-F238E27FC236}">
                  <a16:creationId xmlns:a16="http://schemas.microsoft.com/office/drawing/2014/main" id="{4CDE26FB-772B-4052-9CFC-D50720B0D6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10632" y="2202810"/>
              <a:ext cx="99913" cy="0"/>
            </a:xfrm>
            <a:prstGeom prst="lin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Line 481">
              <a:extLst>
                <a:ext uri="{FF2B5EF4-FFF2-40B4-BE49-F238E27FC236}">
                  <a16:creationId xmlns:a16="http://schemas.microsoft.com/office/drawing/2014/main" id="{EDC0451A-9A09-4907-8B3B-819847791A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62184" y="2799073"/>
              <a:ext cx="1174738" cy="1322"/>
            </a:xfrm>
            <a:prstGeom prst="line">
              <a:avLst/>
            </a:prstGeom>
            <a:noFill/>
            <a:ln w="12700" cmpd="sng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anchor="ctr"/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DFF4B878-5773-4767-B1CF-7D862160CF30}"/>
                </a:ext>
              </a:extLst>
            </p:cNvPr>
            <p:cNvSpPr txBox="1"/>
            <p:nvPr/>
          </p:nvSpPr>
          <p:spPr>
            <a:xfrm rot="16200000">
              <a:off x="3096855" y="1822281"/>
              <a:ext cx="1195192" cy="32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iR-31-3p</a:t>
              </a: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mock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8A6C2357-4238-49A6-8DF6-2F4B65D51172}"/>
                </a:ext>
              </a:extLst>
            </p:cNvPr>
            <p:cNvSpPr txBox="1"/>
            <p:nvPr/>
          </p:nvSpPr>
          <p:spPr>
            <a:xfrm rot="16200000">
              <a:off x="4075737" y="2885339"/>
              <a:ext cx="389870" cy="2051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EDD7BFB7-4D98-45F7-BD89-74B5A5B52802}"/>
                </a:ext>
              </a:extLst>
            </p:cNvPr>
            <p:cNvSpPr txBox="1"/>
            <p:nvPr/>
          </p:nvSpPr>
          <p:spPr>
            <a:xfrm rot="16200000">
              <a:off x="4310194" y="2917399"/>
              <a:ext cx="448016" cy="2051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D9738D69-7C1C-4840-B45C-FFDEB51434C2}"/>
                </a:ext>
              </a:extLst>
            </p:cNvPr>
            <p:cNvSpPr txBox="1"/>
            <p:nvPr/>
          </p:nvSpPr>
          <p:spPr>
            <a:xfrm rot="16200000">
              <a:off x="4273060" y="3245213"/>
              <a:ext cx="1042558" cy="2051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iR-31-3p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H (10nM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F4F0D2CB-9ED4-40EC-9A97-954C92F83C80}"/>
                </a:ext>
              </a:extLst>
            </p:cNvPr>
            <p:cNvSpPr txBox="1"/>
            <p:nvPr/>
          </p:nvSpPr>
          <p:spPr>
            <a:xfrm rot="16200000">
              <a:off x="4537104" y="3245213"/>
              <a:ext cx="1042558" cy="2051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iR-31-3p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H (30nM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23B17A69-3965-4567-B2D9-4FF96158A05C}"/>
                </a:ext>
              </a:extLst>
            </p:cNvPr>
            <p:cNvSpPr txBox="1"/>
            <p:nvPr/>
          </p:nvSpPr>
          <p:spPr>
            <a:xfrm>
              <a:off x="4075202" y="851344"/>
              <a:ext cx="372825" cy="195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SAS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588C7F84-8B06-4C65-9A7E-8561F697052E}"/>
                </a:ext>
              </a:extLst>
            </p:cNvPr>
            <p:cNvCxnSpPr/>
            <p:nvPr/>
          </p:nvCxnSpPr>
          <p:spPr>
            <a:xfrm>
              <a:off x="4530395" y="1470225"/>
              <a:ext cx="30003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CE4A4E4A-3D18-4933-B119-37DA2C1D56A1}"/>
                </a:ext>
              </a:extLst>
            </p:cNvPr>
            <p:cNvCxnSpPr/>
            <p:nvPr/>
          </p:nvCxnSpPr>
          <p:spPr>
            <a:xfrm>
              <a:off x="4530395" y="1326280"/>
              <a:ext cx="54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C0AEF44A-E19B-4514-9FA5-A6B963F68CFF}"/>
                </a:ext>
              </a:extLst>
            </p:cNvPr>
            <p:cNvSpPr txBox="1"/>
            <p:nvPr/>
          </p:nvSpPr>
          <p:spPr>
            <a:xfrm>
              <a:off x="4569276" y="1149497"/>
              <a:ext cx="484276" cy="1674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7A0F29D5-8D01-4479-8D98-170FDC498BCF}"/>
                </a:ext>
              </a:extLst>
            </p:cNvPr>
            <p:cNvSpPr txBox="1"/>
            <p:nvPr/>
          </p:nvSpPr>
          <p:spPr>
            <a:xfrm>
              <a:off x="4426399" y="1301897"/>
              <a:ext cx="484276" cy="1674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6" name="グループ化 45">
            <a:extLst>
              <a:ext uri="{FF2B5EF4-FFF2-40B4-BE49-F238E27FC236}">
                <a16:creationId xmlns:a16="http://schemas.microsoft.com/office/drawing/2014/main" id="{4E47A056-DCBF-447B-84F8-010FF4E2C31C}"/>
              </a:ext>
            </a:extLst>
          </p:cNvPr>
          <p:cNvGrpSpPr/>
          <p:nvPr/>
        </p:nvGrpSpPr>
        <p:grpSpPr>
          <a:xfrm>
            <a:off x="1396333" y="4524135"/>
            <a:ext cx="1711748" cy="3071302"/>
            <a:chOff x="1396335" y="4437507"/>
            <a:chExt cx="1711748" cy="3071302"/>
          </a:xfrm>
        </p:grpSpPr>
        <p:sp>
          <p:nvSpPr>
            <p:cNvPr id="47" name="Line 465">
              <a:extLst>
                <a:ext uri="{FF2B5EF4-FFF2-40B4-BE49-F238E27FC236}">
                  <a16:creationId xmlns:a16="http://schemas.microsoft.com/office/drawing/2014/main" id="{41E8AB8B-A674-4095-AD96-5CA14D758B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89779" y="4806207"/>
              <a:ext cx="0" cy="1584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anchor="ctr"/>
            <a:lstStyle/>
            <a:p>
              <a:endParaRPr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Rectangle 175">
              <a:extLst>
                <a:ext uri="{FF2B5EF4-FFF2-40B4-BE49-F238E27FC236}">
                  <a16:creationId xmlns:a16="http://schemas.microsoft.com/office/drawing/2014/main" id="{F6478760-7E66-440D-AF12-EBDFCFD7C0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2115" y="6334977"/>
              <a:ext cx="5770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Line 261">
              <a:extLst>
                <a:ext uri="{FF2B5EF4-FFF2-40B4-BE49-F238E27FC236}">
                  <a16:creationId xmlns:a16="http://schemas.microsoft.com/office/drawing/2014/main" id="{B555244E-EC0A-4E0A-ADA6-8491140B54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36876" y="6146867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Line 263">
              <a:extLst>
                <a:ext uri="{FF2B5EF4-FFF2-40B4-BE49-F238E27FC236}">
                  <a16:creationId xmlns:a16="http://schemas.microsoft.com/office/drawing/2014/main" id="{2CF5AFEE-57C8-4BF1-927C-7F497770FC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36876" y="5907155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Line 265">
              <a:extLst>
                <a:ext uri="{FF2B5EF4-FFF2-40B4-BE49-F238E27FC236}">
                  <a16:creationId xmlns:a16="http://schemas.microsoft.com/office/drawing/2014/main" id="{DA4BB740-FB5C-40F0-86A5-79C6B311C2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36876" y="5667443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Line 267">
              <a:extLst>
                <a:ext uri="{FF2B5EF4-FFF2-40B4-BE49-F238E27FC236}">
                  <a16:creationId xmlns:a16="http://schemas.microsoft.com/office/drawing/2014/main" id="{D412387F-3ADC-4A81-898A-73BD645A67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36876" y="5427731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Line 269">
              <a:extLst>
                <a:ext uri="{FF2B5EF4-FFF2-40B4-BE49-F238E27FC236}">
                  <a16:creationId xmlns:a16="http://schemas.microsoft.com/office/drawing/2014/main" id="{7EFB4B38-5EB9-4D80-B08F-FC7C1805E2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36876" y="5188019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Line 271">
              <a:extLst>
                <a:ext uri="{FF2B5EF4-FFF2-40B4-BE49-F238E27FC236}">
                  <a16:creationId xmlns:a16="http://schemas.microsoft.com/office/drawing/2014/main" id="{1DA97D1F-052F-461F-8EFA-DC44D727C4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36876" y="4952564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Rectangle 175">
              <a:extLst>
                <a:ext uri="{FF2B5EF4-FFF2-40B4-BE49-F238E27FC236}">
                  <a16:creationId xmlns:a16="http://schemas.microsoft.com/office/drawing/2014/main" id="{5ECF2EDE-4B81-4E0C-9747-169812BE1E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4408" y="6095004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Rectangle 177">
              <a:extLst>
                <a:ext uri="{FF2B5EF4-FFF2-40B4-BE49-F238E27FC236}">
                  <a16:creationId xmlns:a16="http://schemas.microsoft.com/office/drawing/2014/main" id="{8A04EF19-B793-4620-8478-A4034C8E51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4408" y="585502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Rectangle 179">
              <a:extLst>
                <a:ext uri="{FF2B5EF4-FFF2-40B4-BE49-F238E27FC236}">
                  <a16:creationId xmlns:a16="http://schemas.microsoft.com/office/drawing/2014/main" id="{5FF5499A-FC63-40A5-A6D7-40328A08F7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4408" y="5615052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Rectangle 181">
              <a:extLst>
                <a:ext uri="{FF2B5EF4-FFF2-40B4-BE49-F238E27FC236}">
                  <a16:creationId xmlns:a16="http://schemas.microsoft.com/office/drawing/2014/main" id="{D26F9C28-5BC8-45DB-81BB-D72B7D2025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4408" y="537507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Rectangle 183">
              <a:extLst>
                <a:ext uri="{FF2B5EF4-FFF2-40B4-BE49-F238E27FC236}">
                  <a16:creationId xmlns:a16="http://schemas.microsoft.com/office/drawing/2014/main" id="{BD28CEED-6403-4584-8A9F-D31714FD75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26698" y="5135100"/>
              <a:ext cx="1731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Rectangle 185">
              <a:extLst>
                <a:ext uri="{FF2B5EF4-FFF2-40B4-BE49-F238E27FC236}">
                  <a16:creationId xmlns:a16="http://schemas.microsoft.com/office/drawing/2014/main" id="{C6F84145-C435-4616-B7D4-91C351031A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26698" y="4895124"/>
              <a:ext cx="1731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Rectangle 185">
              <a:extLst>
                <a:ext uri="{FF2B5EF4-FFF2-40B4-BE49-F238E27FC236}">
                  <a16:creationId xmlns:a16="http://schemas.microsoft.com/office/drawing/2014/main" id="{8BF62EE2-3AD4-4D82-91E5-902B6D3DD9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1125" y="4721300"/>
              <a:ext cx="15869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%)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Line 152">
              <a:extLst>
                <a:ext uri="{FF2B5EF4-FFF2-40B4-BE49-F238E27FC236}">
                  <a16:creationId xmlns:a16="http://schemas.microsoft.com/office/drawing/2014/main" id="{0B87F6F6-D356-4662-9B70-2D5BCB6BB6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31749" y="6236662"/>
              <a:ext cx="0" cy="72000"/>
            </a:xfrm>
            <a:prstGeom prst="lin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Rectangle 69">
              <a:extLst>
                <a:ext uri="{FF2B5EF4-FFF2-40B4-BE49-F238E27FC236}">
                  <a16:creationId xmlns:a16="http://schemas.microsoft.com/office/drawing/2014/main" id="{5BF82D08-E62C-4100-84DD-19C597DF96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1836" y="6257925"/>
              <a:ext cx="199827" cy="131646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4" name="グループ化 63">
              <a:extLst>
                <a:ext uri="{FF2B5EF4-FFF2-40B4-BE49-F238E27FC236}">
                  <a16:creationId xmlns:a16="http://schemas.microsoft.com/office/drawing/2014/main" id="{4DFFE22C-3B3B-4F7C-8AF1-1D8551DC9068}"/>
                </a:ext>
              </a:extLst>
            </p:cNvPr>
            <p:cNvGrpSpPr/>
            <p:nvPr/>
          </p:nvGrpSpPr>
          <p:grpSpPr>
            <a:xfrm>
              <a:off x="2097062" y="5170173"/>
              <a:ext cx="99913" cy="108000"/>
              <a:chOff x="2097265" y="1568012"/>
              <a:chExt cx="99913" cy="108000"/>
            </a:xfrm>
          </p:grpSpPr>
          <p:sp>
            <p:nvSpPr>
              <p:cNvPr id="84" name="Line 140">
                <a:extLst>
                  <a:ext uri="{FF2B5EF4-FFF2-40B4-BE49-F238E27FC236}">
                    <a16:creationId xmlns:a16="http://schemas.microsoft.com/office/drawing/2014/main" id="{CD49258D-808B-4CC5-AB2C-B1F495577C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7221" y="1568012"/>
                <a:ext cx="0" cy="108000"/>
              </a:xfrm>
              <a:prstGeom prst="lin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Line 141">
                <a:extLst>
                  <a:ext uri="{FF2B5EF4-FFF2-40B4-BE49-F238E27FC236}">
                    <a16:creationId xmlns:a16="http://schemas.microsoft.com/office/drawing/2014/main" id="{F3D26B5B-05A2-4BBB-AEFB-23E89C625A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97265" y="1568013"/>
                <a:ext cx="99913" cy="0"/>
              </a:xfrm>
              <a:prstGeom prst="lin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5" name="Rectangle 142">
              <a:extLst>
                <a:ext uri="{FF2B5EF4-FFF2-40B4-BE49-F238E27FC236}">
                  <a16:creationId xmlns:a16="http://schemas.microsoft.com/office/drawing/2014/main" id="{73C90B9A-B123-4C53-8996-72B7745E90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7105" y="5190907"/>
              <a:ext cx="199827" cy="119866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Line 146">
              <a:extLst>
                <a:ext uri="{FF2B5EF4-FFF2-40B4-BE49-F238E27FC236}">
                  <a16:creationId xmlns:a16="http://schemas.microsoft.com/office/drawing/2014/main" id="{E7B7F4FC-5917-4D8C-8F1A-A84D3B8F7D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8595" y="5463385"/>
              <a:ext cx="0" cy="144000"/>
            </a:xfrm>
            <a:prstGeom prst="line">
              <a:avLst/>
            </a:prstGeom>
            <a:solidFill>
              <a:schemeClr val="bg1">
                <a:lumMod val="9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Line 147">
              <a:extLst>
                <a:ext uri="{FF2B5EF4-FFF2-40B4-BE49-F238E27FC236}">
                  <a16:creationId xmlns:a16="http://schemas.microsoft.com/office/drawing/2014/main" id="{C6EA1D68-5A27-4D49-A905-B7C0674D49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58638" y="5462618"/>
              <a:ext cx="99914" cy="0"/>
            </a:xfrm>
            <a:prstGeom prst="line">
              <a:avLst/>
            </a:prstGeom>
            <a:solidFill>
              <a:schemeClr val="bg1">
                <a:lumMod val="9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Rectangle 148">
              <a:extLst>
                <a:ext uri="{FF2B5EF4-FFF2-40B4-BE49-F238E27FC236}">
                  <a16:creationId xmlns:a16="http://schemas.microsoft.com/office/drawing/2014/main" id="{7DF69DA4-BFFC-416D-8BF8-725622B310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8682" y="5491163"/>
              <a:ext cx="199827" cy="89840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Line 152">
              <a:extLst>
                <a:ext uri="{FF2B5EF4-FFF2-40B4-BE49-F238E27FC236}">
                  <a16:creationId xmlns:a16="http://schemas.microsoft.com/office/drawing/2014/main" id="{FB174BD3-9968-4875-883D-243D391E77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65409" y="6218957"/>
              <a:ext cx="0" cy="108000"/>
            </a:xfrm>
            <a:prstGeom prst="lin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Line 153">
              <a:extLst>
                <a:ext uri="{FF2B5EF4-FFF2-40B4-BE49-F238E27FC236}">
                  <a16:creationId xmlns:a16="http://schemas.microsoft.com/office/drawing/2014/main" id="{3AEB1DC9-A524-49A4-A8B5-D15A423CE2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15452" y="6223879"/>
              <a:ext cx="99914" cy="0"/>
            </a:xfrm>
            <a:prstGeom prst="lin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Rectangle 154">
              <a:extLst>
                <a:ext uri="{FF2B5EF4-FFF2-40B4-BE49-F238E27FC236}">
                  <a16:creationId xmlns:a16="http://schemas.microsoft.com/office/drawing/2014/main" id="{C3A6DA31-102B-46A5-8F42-05EF3C52F3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0259" y="6238875"/>
              <a:ext cx="199827" cy="150696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Line 153">
              <a:extLst>
                <a:ext uri="{FF2B5EF4-FFF2-40B4-BE49-F238E27FC236}">
                  <a16:creationId xmlns:a16="http://schemas.microsoft.com/office/drawing/2014/main" id="{F3F4E043-3DAB-430C-9124-2579608B88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81793" y="6236661"/>
              <a:ext cx="99913" cy="0"/>
            </a:xfrm>
            <a:prstGeom prst="lin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Line 481">
              <a:extLst>
                <a:ext uri="{FF2B5EF4-FFF2-40B4-BE49-F238E27FC236}">
                  <a16:creationId xmlns:a16="http://schemas.microsoft.com/office/drawing/2014/main" id="{E3291036-7D0D-476E-9582-A087E1DC8E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33345" y="6385236"/>
              <a:ext cx="1174738" cy="1322"/>
            </a:xfrm>
            <a:prstGeom prst="line">
              <a:avLst/>
            </a:prstGeom>
            <a:noFill/>
            <a:ln w="12700" cmpd="sng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anchor="ctr"/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E4FC7758-6C09-4E50-ADAE-79E44C1A0F94}"/>
                </a:ext>
              </a:extLst>
            </p:cNvPr>
            <p:cNvSpPr txBox="1"/>
            <p:nvPr/>
          </p:nvSpPr>
          <p:spPr>
            <a:xfrm rot="16200000">
              <a:off x="906617" y="5400388"/>
              <a:ext cx="131799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iR-31-5p</a:t>
              </a: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mock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178FEDD3-38ED-4158-8728-78307943DCC0}"/>
                </a:ext>
              </a:extLst>
            </p:cNvPr>
            <p:cNvSpPr txBox="1"/>
            <p:nvPr/>
          </p:nvSpPr>
          <p:spPr>
            <a:xfrm rot="16200000">
              <a:off x="1926870" y="6466376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557D89C1-BFC4-49D1-B758-D5729657B6C0}"/>
                </a:ext>
              </a:extLst>
            </p:cNvPr>
            <p:cNvSpPr txBox="1"/>
            <p:nvPr/>
          </p:nvSpPr>
          <p:spPr>
            <a:xfrm rot="16200000">
              <a:off x="2158340" y="6498435"/>
              <a:ext cx="4940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FFE1B57D-1F74-45A2-8883-B0A7DBC0A6CD}"/>
                </a:ext>
              </a:extLst>
            </p:cNvPr>
            <p:cNvSpPr txBox="1"/>
            <p:nvPr/>
          </p:nvSpPr>
          <p:spPr>
            <a:xfrm rot="16200000">
              <a:off x="2090664" y="6826250"/>
              <a:ext cx="11496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iR-31-5p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H (10nM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8CC3746C-AAAD-4003-A68D-33B49AE21084}"/>
                </a:ext>
              </a:extLst>
            </p:cNvPr>
            <p:cNvSpPr txBox="1"/>
            <p:nvPr/>
          </p:nvSpPr>
          <p:spPr>
            <a:xfrm rot="16200000">
              <a:off x="2354708" y="6826250"/>
              <a:ext cx="11496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iR-31-5p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H (30nM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7EACBD16-3FF3-4EEA-ADAC-18515D35D741}"/>
                </a:ext>
              </a:extLst>
            </p:cNvPr>
            <p:cNvSpPr txBox="1"/>
            <p:nvPr/>
          </p:nvSpPr>
          <p:spPr>
            <a:xfrm>
              <a:off x="1946363" y="4437507"/>
              <a:ext cx="4924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SC-2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8CBFE51C-8037-4DF3-A2C5-AC60C8D1B21C}"/>
                </a:ext>
              </a:extLst>
            </p:cNvPr>
            <p:cNvCxnSpPr/>
            <p:nvPr/>
          </p:nvCxnSpPr>
          <p:spPr>
            <a:xfrm>
              <a:off x="2401556" y="5032575"/>
              <a:ext cx="30003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線コネクタ 80">
              <a:extLst>
                <a:ext uri="{FF2B5EF4-FFF2-40B4-BE49-F238E27FC236}">
                  <a16:creationId xmlns:a16="http://schemas.microsoft.com/office/drawing/2014/main" id="{F0F3099C-DEDF-4F85-8643-D98B4A6DE9DC}"/>
                </a:ext>
              </a:extLst>
            </p:cNvPr>
            <p:cNvCxnSpPr/>
            <p:nvPr/>
          </p:nvCxnSpPr>
          <p:spPr>
            <a:xfrm>
              <a:off x="2401556" y="4888630"/>
              <a:ext cx="54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B1CCEC19-6D51-4FC4-9D8C-A32CD4F20B5A}"/>
                </a:ext>
              </a:extLst>
            </p:cNvPr>
            <p:cNvSpPr txBox="1"/>
            <p:nvPr/>
          </p:nvSpPr>
          <p:spPr>
            <a:xfrm>
              <a:off x="2440437" y="4711847"/>
              <a:ext cx="5084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2A2396F2-9F16-44F1-BE53-A63CB24595CC}"/>
                </a:ext>
              </a:extLst>
            </p:cNvPr>
            <p:cNvSpPr txBox="1"/>
            <p:nvPr/>
          </p:nvSpPr>
          <p:spPr>
            <a:xfrm>
              <a:off x="2297560" y="4864247"/>
              <a:ext cx="5084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6" name="グループ化 85">
            <a:extLst>
              <a:ext uri="{FF2B5EF4-FFF2-40B4-BE49-F238E27FC236}">
                <a16:creationId xmlns:a16="http://schemas.microsoft.com/office/drawing/2014/main" id="{1854D82A-8F0C-4CB2-9064-CE8D24C1D261}"/>
              </a:ext>
            </a:extLst>
          </p:cNvPr>
          <p:cNvGrpSpPr/>
          <p:nvPr/>
        </p:nvGrpSpPr>
        <p:grpSpPr>
          <a:xfrm>
            <a:off x="3553748" y="4528897"/>
            <a:ext cx="1711748" cy="3071302"/>
            <a:chOff x="3553749" y="4442269"/>
            <a:chExt cx="1711748" cy="3071302"/>
          </a:xfrm>
        </p:grpSpPr>
        <p:sp>
          <p:nvSpPr>
            <p:cNvPr id="87" name="Line 465">
              <a:extLst>
                <a:ext uri="{FF2B5EF4-FFF2-40B4-BE49-F238E27FC236}">
                  <a16:creationId xmlns:a16="http://schemas.microsoft.com/office/drawing/2014/main" id="{07DE6802-BD58-407D-9020-5C1195A02C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47193" y="4810969"/>
              <a:ext cx="0" cy="1584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anchor="ctr"/>
            <a:lstStyle/>
            <a:p>
              <a:endParaRPr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Rectangle 175">
              <a:extLst>
                <a:ext uri="{FF2B5EF4-FFF2-40B4-BE49-F238E27FC236}">
                  <a16:creationId xmlns:a16="http://schemas.microsoft.com/office/drawing/2014/main" id="{9B56893E-5D42-4C4D-9E78-9D5F9A2C5A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9529" y="6339739"/>
              <a:ext cx="5770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Line 261">
              <a:extLst>
                <a:ext uri="{FF2B5EF4-FFF2-40B4-BE49-F238E27FC236}">
                  <a16:creationId xmlns:a16="http://schemas.microsoft.com/office/drawing/2014/main" id="{BB40F3A9-CF09-4ADF-A125-8C547B90A3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94290" y="6151629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Line 263">
              <a:extLst>
                <a:ext uri="{FF2B5EF4-FFF2-40B4-BE49-F238E27FC236}">
                  <a16:creationId xmlns:a16="http://schemas.microsoft.com/office/drawing/2014/main" id="{4C7BE147-45AE-44F6-8538-FCBD1F2798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94290" y="5911917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Line 265">
              <a:extLst>
                <a:ext uri="{FF2B5EF4-FFF2-40B4-BE49-F238E27FC236}">
                  <a16:creationId xmlns:a16="http://schemas.microsoft.com/office/drawing/2014/main" id="{599B1785-C83B-4E85-98E8-B3AD6AD564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94290" y="5672205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Line 267">
              <a:extLst>
                <a:ext uri="{FF2B5EF4-FFF2-40B4-BE49-F238E27FC236}">
                  <a16:creationId xmlns:a16="http://schemas.microsoft.com/office/drawing/2014/main" id="{61465DE5-D81F-4ABB-93B0-43920D19B6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94290" y="5432493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Line 269">
              <a:extLst>
                <a:ext uri="{FF2B5EF4-FFF2-40B4-BE49-F238E27FC236}">
                  <a16:creationId xmlns:a16="http://schemas.microsoft.com/office/drawing/2014/main" id="{F2C70320-8DB4-4E42-B0B9-91A3CC525C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94290" y="5192781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Line 271">
              <a:extLst>
                <a:ext uri="{FF2B5EF4-FFF2-40B4-BE49-F238E27FC236}">
                  <a16:creationId xmlns:a16="http://schemas.microsoft.com/office/drawing/2014/main" id="{7B811D0B-00E6-4FE5-A977-DD1A093383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94290" y="4957326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Rectangle 175">
              <a:extLst>
                <a:ext uri="{FF2B5EF4-FFF2-40B4-BE49-F238E27FC236}">
                  <a16:creationId xmlns:a16="http://schemas.microsoft.com/office/drawing/2014/main" id="{AF7FA28E-FB9D-4886-AC4B-31F1A293FD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1822" y="609976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Rectangle 177">
              <a:extLst>
                <a:ext uri="{FF2B5EF4-FFF2-40B4-BE49-F238E27FC236}">
                  <a16:creationId xmlns:a16="http://schemas.microsoft.com/office/drawing/2014/main" id="{E203F8B9-331F-44D4-A329-BD23E439E2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1822" y="5859790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Rectangle 179">
              <a:extLst>
                <a:ext uri="{FF2B5EF4-FFF2-40B4-BE49-F238E27FC236}">
                  <a16:creationId xmlns:a16="http://schemas.microsoft.com/office/drawing/2014/main" id="{CF18D28D-0B13-42FF-8AA4-70FB2AB078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1822" y="5619814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Rectangle 181">
              <a:extLst>
                <a:ext uri="{FF2B5EF4-FFF2-40B4-BE49-F238E27FC236}">
                  <a16:creationId xmlns:a16="http://schemas.microsoft.com/office/drawing/2014/main" id="{B1596E06-B701-4FB9-B367-919E2FC6C0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1822" y="5379838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Rectangle 183">
              <a:extLst>
                <a:ext uri="{FF2B5EF4-FFF2-40B4-BE49-F238E27FC236}">
                  <a16:creationId xmlns:a16="http://schemas.microsoft.com/office/drawing/2014/main" id="{87129481-8D21-41FA-8FBF-39CB195F86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4112" y="5139862"/>
              <a:ext cx="1731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Rectangle 185">
              <a:extLst>
                <a:ext uri="{FF2B5EF4-FFF2-40B4-BE49-F238E27FC236}">
                  <a16:creationId xmlns:a16="http://schemas.microsoft.com/office/drawing/2014/main" id="{99681C09-6F22-47DB-AA2F-F05358D6D7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4112" y="4899886"/>
              <a:ext cx="1731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Rectangle 185">
              <a:extLst>
                <a:ext uri="{FF2B5EF4-FFF2-40B4-BE49-F238E27FC236}">
                  <a16:creationId xmlns:a16="http://schemas.microsoft.com/office/drawing/2014/main" id="{DA4C6F44-06AB-4F09-BAF6-8B8E1EC99B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8539" y="4726062"/>
              <a:ext cx="15869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%)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Rectangle 69">
              <a:extLst>
                <a:ext uri="{FF2B5EF4-FFF2-40B4-BE49-F238E27FC236}">
                  <a16:creationId xmlns:a16="http://schemas.microsoft.com/office/drawing/2014/main" id="{F7756F54-9537-49EA-9FE2-9E767457AC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9250" y="5900738"/>
              <a:ext cx="199827" cy="493595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3" name="グループ化 102">
              <a:extLst>
                <a:ext uri="{FF2B5EF4-FFF2-40B4-BE49-F238E27FC236}">
                  <a16:creationId xmlns:a16="http://schemas.microsoft.com/office/drawing/2014/main" id="{8D53D4AE-5412-4FC3-9E73-6193EF446331}"/>
                </a:ext>
              </a:extLst>
            </p:cNvPr>
            <p:cNvGrpSpPr/>
            <p:nvPr/>
          </p:nvGrpSpPr>
          <p:grpSpPr>
            <a:xfrm>
              <a:off x="4254476" y="5013003"/>
              <a:ext cx="99913" cy="216000"/>
              <a:chOff x="2097265" y="1568012"/>
              <a:chExt cx="99913" cy="216000"/>
            </a:xfrm>
          </p:grpSpPr>
          <p:sp>
            <p:nvSpPr>
              <p:cNvPr id="126" name="Line 140">
                <a:extLst>
                  <a:ext uri="{FF2B5EF4-FFF2-40B4-BE49-F238E27FC236}">
                    <a16:creationId xmlns:a16="http://schemas.microsoft.com/office/drawing/2014/main" id="{BD802979-F21D-40BC-8056-219E759AF6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7221" y="1568012"/>
                <a:ext cx="0" cy="216000"/>
              </a:xfrm>
              <a:prstGeom prst="lin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Line 141">
                <a:extLst>
                  <a:ext uri="{FF2B5EF4-FFF2-40B4-BE49-F238E27FC236}">
                    <a16:creationId xmlns:a16="http://schemas.microsoft.com/office/drawing/2014/main" id="{877961CE-1D7F-4FAB-9540-E06A5E393C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97265" y="1568013"/>
                <a:ext cx="99913" cy="0"/>
              </a:xfrm>
              <a:prstGeom prst="lin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4" name="Rectangle 142">
              <a:extLst>
                <a:ext uri="{FF2B5EF4-FFF2-40B4-BE49-F238E27FC236}">
                  <a16:creationId xmlns:a16="http://schemas.microsoft.com/office/drawing/2014/main" id="{2F39BF05-6419-4B85-B89E-FAE688CF2A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04519" y="5195669"/>
              <a:ext cx="199827" cy="119866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5" name="グループ化 104">
              <a:extLst>
                <a:ext uri="{FF2B5EF4-FFF2-40B4-BE49-F238E27FC236}">
                  <a16:creationId xmlns:a16="http://schemas.microsoft.com/office/drawing/2014/main" id="{1B2162F6-4A6C-49FA-8C57-42D6C9FDE7E8}"/>
                </a:ext>
              </a:extLst>
            </p:cNvPr>
            <p:cNvGrpSpPr/>
            <p:nvPr/>
          </p:nvGrpSpPr>
          <p:grpSpPr>
            <a:xfrm>
              <a:off x="4516052" y="5391179"/>
              <a:ext cx="99914" cy="144767"/>
              <a:chOff x="4516052" y="5391179"/>
              <a:chExt cx="99914" cy="144767"/>
            </a:xfrm>
          </p:grpSpPr>
          <p:sp>
            <p:nvSpPr>
              <p:cNvPr id="124" name="Line 146">
                <a:extLst>
                  <a:ext uri="{FF2B5EF4-FFF2-40B4-BE49-F238E27FC236}">
                    <a16:creationId xmlns:a16="http://schemas.microsoft.com/office/drawing/2014/main" id="{3DF22BF8-203A-451A-940E-6863827572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66009" y="5391946"/>
                <a:ext cx="0" cy="144000"/>
              </a:xfrm>
              <a:prstGeom prst="line">
                <a:avLst/>
              </a:prstGeom>
              <a:solidFill>
                <a:schemeClr val="bg1">
                  <a:lumMod val="95000"/>
                </a:schemeClr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Line 147">
                <a:extLst>
                  <a:ext uri="{FF2B5EF4-FFF2-40B4-BE49-F238E27FC236}">
                    <a16:creationId xmlns:a16="http://schemas.microsoft.com/office/drawing/2014/main" id="{B4026BDC-49EA-4F0C-A1FC-1A9AF1E5A6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16052" y="5391179"/>
                <a:ext cx="99914" cy="0"/>
              </a:xfrm>
              <a:prstGeom prst="line">
                <a:avLst/>
              </a:prstGeom>
              <a:solidFill>
                <a:schemeClr val="bg1">
                  <a:lumMod val="95000"/>
                </a:schemeClr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6" name="Rectangle 148">
              <a:extLst>
                <a:ext uri="{FF2B5EF4-FFF2-40B4-BE49-F238E27FC236}">
                  <a16:creationId xmlns:a16="http://schemas.microsoft.com/office/drawing/2014/main" id="{92077517-31E0-4212-9B05-B6E5887B45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66096" y="5429250"/>
              <a:ext cx="199827" cy="965081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Line 152">
              <a:extLst>
                <a:ext uri="{FF2B5EF4-FFF2-40B4-BE49-F238E27FC236}">
                  <a16:creationId xmlns:a16="http://schemas.microsoft.com/office/drawing/2014/main" id="{4A9766C0-B67D-43CC-86C8-F759B3DB58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22823" y="5647448"/>
              <a:ext cx="0" cy="108000"/>
            </a:xfrm>
            <a:prstGeom prst="lin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Line 153">
              <a:extLst>
                <a:ext uri="{FF2B5EF4-FFF2-40B4-BE49-F238E27FC236}">
                  <a16:creationId xmlns:a16="http://schemas.microsoft.com/office/drawing/2014/main" id="{542CD7D4-A31C-4C02-963E-8A6EE92CCF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72866" y="5652370"/>
              <a:ext cx="99914" cy="0"/>
            </a:xfrm>
            <a:prstGeom prst="lin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Rectangle 154">
              <a:extLst>
                <a:ext uri="{FF2B5EF4-FFF2-40B4-BE49-F238E27FC236}">
                  <a16:creationId xmlns:a16="http://schemas.microsoft.com/office/drawing/2014/main" id="{8198E58E-7A3B-4000-B1EB-051B823C1C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7673" y="5672138"/>
              <a:ext cx="199827" cy="722195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0" name="グループ化 109">
              <a:extLst>
                <a:ext uri="{FF2B5EF4-FFF2-40B4-BE49-F238E27FC236}">
                  <a16:creationId xmlns:a16="http://schemas.microsoft.com/office/drawing/2014/main" id="{254AF7A7-4907-461C-BAB5-3FBD7EB28C41}"/>
                </a:ext>
              </a:extLst>
            </p:cNvPr>
            <p:cNvGrpSpPr/>
            <p:nvPr/>
          </p:nvGrpSpPr>
          <p:grpSpPr>
            <a:xfrm>
              <a:off x="5039207" y="5860414"/>
              <a:ext cx="99913" cy="76764"/>
              <a:chOff x="5039207" y="5860414"/>
              <a:chExt cx="99913" cy="76764"/>
            </a:xfrm>
          </p:grpSpPr>
          <p:sp>
            <p:nvSpPr>
              <p:cNvPr id="122" name="Line 152">
                <a:extLst>
                  <a:ext uri="{FF2B5EF4-FFF2-40B4-BE49-F238E27FC236}">
                    <a16:creationId xmlns:a16="http://schemas.microsoft.com/office/drawing/2014/main" id="{7AE4F879-4137-456E-A467-4CAC98AD79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89163" y="5865178"/>
                <a:ext cx="0" cy="72000"/>
              </a:xfrm>
              <a:prstGeom prst="line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Line 153">
                <a:extLst>
                  <a:ext uri="{FF2B5EF4-FFF2-40B4-BE49-F238E27FC236}">
                    <a16:creationId xmlns:a16="http://schemas.microsoft.com/office/drawing/2014/main" id="{6720B30F-03CE-4732-AE39-955ED9B22F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39207" y="5860414"/>
                <a:ext cx="99913" cy="0"/>
              </a:xfrm>
              <a:prstGeom prst="line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1" name="Line 481">
              <a:extLst>
                <a:ext uri="{FF2B5EF4-FFF2-40B4-BE49-F238E27FC236}">
                  <a16:creationId xmlns:a16="http://schemas.microsoft.com/office/drawing/2014/main" id="{2E119A91-904C-45FC-B82A-E29B5F7AF2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90759" y="6389998"/>
              <a:ext cx="1174738" cy="1322"/>
            </a:xfrm>
            <a:prstGeom prst="line">
              <a:avLst/>
            </a:prstGeom>
            <a:noFill/>
            <a:ln w="12700" cmpd="sng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anchor="ctr"/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21C6C0CB-B5A9-4665-8354-55C3A3E892E1}"/>
                </a:ext>
              </a:extLst>
            </p:cNvPr>
            <p:cNvSpPr txBox="1"/>
            <p:nvPr/>
          </p:nvSpPr>
          <p:spPr>
            <a:xfrm rot="16200000">
              <a:off x="3064031" y="5405150"/>
              <a:ext cx="131799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iR-31-3p</a:t>
              </a: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mock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FC95111E-B86F-4D33-B301-781DDF2704AF}"/>
                </a:ext>
              </a:extLst>
            </p:cNvPr>
            <p:cNvSpPr txBox="1"/>
            <p:nvPr/>
          </p:nvSpPr>
          <p:spPr>
            <a:xfrm rot="16200000">
              <a:off x="4084284" y="6471138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BF78A4A9-2020-44D2-9D2C-332D57F07EF3}"/>
                </a:ext>
              </a:extLst>
            </p:cNvPr>
            <p:cNvSpPr txBox="1"/>
            <p:nvPr/>
          </p:nvSpPr>
          <p:spPr>
            <a:xfrm rot="16200000">
              <a:off x="4315754" y="6503197"/>
              <a:ext cx="4940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C6BF8B09-464F-4DE2-81CA-E81CAABB0796}"/>
                </a:ext>
              </a:extLst>
            </p:cNvPr>
            <p:cNvSpPr txBox="1"/>
            <p:nvPr/>
          </p:nvSpPr>
          <p:spPr>
            <a:xfrm rot="16200000">
              <a:off x="4248078" y="6831012"/>
              <a:ext cx="11496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iR-31-3p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H (10nM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A7AB5D7B-D23F-4550-AD46-47A8A65648B0}"/>
                </a:ext>
              </a:extLst>
            </p:cNvPr>
            <p:cNvSpPr txBox="1"/>
            <p:nvPr/>
          </p:nvSpPr>
          <p:spPr>
            <a:xfrm rot="16200000">
              <a:off x="4512122" y="6831012"/>
              <a:ext cx="11496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iR-31-3p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H (30nM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9F50473E-CA9F-4C42-B244-62AD0ABE2D75}"/>
                </a:ext>
              </a:extLst>
            </p:cNvPr>
            <p:cNvSpPr txBox="1"/>
            <p:nvPr/>
          </p:nvSpPr>
          <p:spPr>
            <a:xfrm>
              <a:off x="4103777" y="4442269"/>
              <a:ext cx="4924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>
                  <a:latin typeface="Arial" panose="020B0604020202020204" pitchFamily="34" charset="0"/>
                  <a:cs typeface="Arial" panose="020B0604020202020204" pitchFamily="34" charset="0"/>
                </a:rPr>
                <a:t>HSC-2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8" name="直線コネクタ 117">
              <a:extLst>
                <a:ext uri="{FF2B5EF4-FFF2-40B4-BE49-F238E27FC236}">
                  <a16:creationId xmlns:a16="http://schemas.microsoft.com/office/drawing/2014/main" id="{846FB5CD-02EA-4690-88A5-90A03EFF6BD0}"/>
                </a:ext>
              </a:extLst>
            </p:cNvPr>
            <p:cNvCxnSpPr/>
            <p:nvPr/>
          </p:nvCxnSpPr>
          <p:spPr>
            <a:xfrm>
              <a:off x="4558970" y="5037337"/>
              <a:ext cx="30003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コネクタ 118">
              <a:extLst>
                <a:ext uri="{FF2B5EF4-FFF2-40B4-BE49-F238E27FC236}">
                  <a16:creationId xmlns:a16="http://schemas.microsoft.com/office/drawing/2014/main" id="{EB041DD1-EE83-402C-9536-F7B4A0EB73D3}"/>
                </a:ext>
              </a:extLst>
            </p:cNvPr>
            <p:cNvCxnSpPr/>
            <p:nvPr/>
          </p:nvCxnSpPr>
          <p:spPr>
            <a:xfrm>
              <a:off x="4558970" y="4893392"/>
              <a:ext cx="54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3D55A632-7E16-4924-9516-E47C658C8F3F}"/>
                </a:ext>
              </a:extLst>
            </p:cNvPr>
            <p:cNvSpPr txBox="1"/>
            <p:nvPr/>
          </p:nvSpPr>
          <p:spPr>
            <a:xfrm>
              <a:off x="4597851" y="4716609"/>
              <a:ext cx="5084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7F3E95C0-586B-426B-A5BF-05C7D216E826}"/>
                </a:ext>
              </a:extLst>
            </p:cNvPr>
            <p:cNvSpPr txBox="1"/>
            <p:nvPr/>
          </p:nvSpPr>
          <p:spPr>
            <a:xfrm>
              <a:off x="4454974" y="4869009"/>
              <a:ext cx="5084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8" name="グループ化 127">
            <a:extLst>
              <a:ext uri="{FF2B5EF4-FFF2-40B4-BE49-F238E27FC236}">
                <a16:creationId xmlns:a16="http://schemas.microsoft.com/office/drawing/2014/main" id="{D2B8591A-1E00-4741-A17C-A671CF15A54B}"/>
              </a:ext>
            </a:extLst>
          </p:cNvPr>
          <p:cNvGrpSpPr/>
          <p:nvPr/>
        </p:nvGrpSpPr>
        <p:grpSpPr>
          <a:xfrm>
            <a:off x="1328787" y="918922"/>
            <a:ext cx="1788820" cy="3327796"/>
            <a:chOff x="1413916" y="832294"/>
            <a:chExt cx="1703693" cy="3017744"/>
          </a:xfrm>
        </p:grpSpPr>
        <p:sp>
          <p:nvSpPr>
            <p:cNvPr id="129" name="Line 465">
              <a:extLst>
                <a:ext uri="{FF2B5EF4-FFF2-40B4-BE49-F238E27FC236}">
                  <a16:creationId xmlns:a16="http://schemas.microsoft.com/office/drawing/2014/main" id="{AAB563C2-8E7E-4653-9D94-D2D8355102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99305" y="1200994"/>
              <a:ext cx="0" cy="1584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anchor="ctr"/>
            <a:lstStyle/>
            <a:p>
              <a:endParaRPr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Rectangle 175">
              <a:extLst>
                <a:ext uri="{FF2B5EF4-FFF2-40B4-BE49-F238E27FC236}">
                  <a16:creationId xmlns:a16="http://schemas.microsoft.com/office/drawing/2014/main" id="{05E02EC4-D2F1-4372-BB36-8ABD03E17F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4388" y="2735499"/>
              <a:ext cx="54962" cy="111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Line 261">
              <a:extLst>
                <a:ext uri="{FF2B5EF4-FFF2-40B4-BE49-F238E27FC236}">
                  <a16:creationId xmlns:a16="http://schemas.microsoft.com/office/drawing/2014/main" id="{F6C78883-C46E-43E6-AF30-07A1547468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46402" y="2541654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Line 263">
              <a:extLst>
                <a:ext uri="{FF2B5EF4-FFF2-40B4-BE49-F238E27FC236}">
                  <a16:creationId xmlns:a16="http://schemas.microsoft.com/office/drawing/2014/main" id="{C0C7EE9F-6D2B-4C54-89C0-2958DF69C3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46402" y="2301942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Line 265">
              <a:extLst>
                <a:ext uri="{FF2B5EF4-FFF2-40B4-BE49-F238E27FC236}">
                  <a16:creationId xmlns:a16="http://schemas.microsoft.com/office/drawing/2014/main" id="{767FB15D-4A17-4E66-BB70-3C0EF9D22E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46402" y="2062230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Line 267">
              <a:extLst>
                <a:ext uri="{FF2B5EF4-FFF2-40B4-BE49-F238E27FC236}">
                  <a16:creationId xmlns:a16="http://schemas.microsoft.com/office/drawing/2014/main" id="{009372E4-F999-44AF-A9EC-CC5E6558E8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46402" y="1822518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Line 269">
              <a:extLst>
                <a:ext uri="{FF2B5EF4-FFF2-40B4-BE49-F238E27FC236}">
                  <a16:creationId xmlns:a16="http://schemas.microsoft.com/office/drawing/2014/main" id="{76751716-1AF0-44D1-ACA6-38780EFE5E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46402" y="1582806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Line 271">
              <a:extLst>
                <a:ext uri="{FF2B5EF4-FFF2-40B4-BE49-F238E27FC236}">
                  <a16:creationId xmlns:a16="http://schemas.microsoft.com/office/drawing/2014/main" id="{1047D301-5466-460C-97E1-54A26D754B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46402" y="1347351"/>
              <a:ext cx="54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Rectangle 175">
              <a:extLst>
                <a:ext uri="{FF2B5EF4-FFF2-40B4-BE49-F238E27FC236}">
                  <a16:creationId xmlns:a16="http://schemas.microsoft.com/office/drawing/2014/main" id="{5CAE6442-9D2F-44CB-80E2-C638CDDCD5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9425" y="2489791"/>
              <a:ext cx="109925" cy="111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Rectangle 177">
              <a:extLst>
                <a:ext uri="{FF2B5EF4-FFF2-40B4-BE49-F238E27FC236}">
                  <a16:creationId xmlns:a16="http://schemas.microsoft.com/office/drawing/2014/main" id="{A210A037-4BBE-436F-B25C-23D6CD5661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9425" y="2249815"/>
              <a:ext cx="109925" cy="111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Rectangle 179">
              <a:extLst>
                <a:ext uri="{FF2B5EF4-FFF2-40B4-BE49-F238E27FC236}">
                  <a16:creationId xmlns:a16="http://schemas.microsoft.com/office/drawing/2014/main" id="{1B56BF47-D81F-4A90-A23D-C987F1C4BA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9425" y="2009839"/>
              <a:ext cx="109925" cy="111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Rectangle 181">
              <a:extLst>
                <a:ext uri="{FF2B5EF4-FFF2-40B4-BE49-F238E27FC236}">
                  <a16:creationId xmlns:a16="http://schemas.microsoft.com/office/drawing/2014/main" id="{84C772AA-007B-4561-A52A-6F02DC0E29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9425" y="1769863"/>
              <a:ext cx="109925" cy="111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Rectangle 183">
              <a:extLst>
                <a:ext uri="{FF2B5EF4-FFF2-40B4-BE49-F238E27FC236}">
                  <a16:creationId xmlns:a16="http://schemas.microsoft.com/office/drawing/2014/main" id="{79D675E8-D90C-4159-BACF-3E2B4B404D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4463" y="1529887"/>
              <a:ext cx="164886" cy="111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Rectangle 185">
              <a:extLst>
                <a:ext uri="{FF2B5EF4-FFF2-40B4-BE49-F238E27FC236}">
                  <a16:creationId xmlns:a16="http://schemas.microsoft.com/office/drawing/2014/main" id="{9761A9F6-C955-4A2A-A4F8-F44BB17E52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4463" y="1289911"/>
              <a:ext cx="164886" cy="111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Rectangle 185">
              <a:extLst>
                <a:ext uri="{FF2B5EF4-FFF2-40B4-BE49-F238E27FC236}">
                  <a16:creationId xmlns:a16="http://schemas.microsoft.com/office/drawing/2014/main" id="{1A8DD22D-59C6-4C6B-A3C7-B64B57AF37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8203" y="1116087"/>
              <a:ext cx="151146" cy="111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%)</a:t>
              </a:r>
              <a:endParaRPr lang="ja-JP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Line 152">
              <a:extLst>
                <a:ext uri="{FF2B5EF4-FFF2-40B4-BE49-F238E27FC236}">
                  <a16:creationId xmlns:a16="http://schemas.microsoft.com/office/drawing/2014/main" id="{738DE179-ABE2-47DC-AB33-665E473121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41275" y="2598108"/>
              <a:ext cx="0" cy="72000"/>
            </a:xfrm>
            <a:prstGeom prst="lin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Rectangle 69">
              <a:extLst>
                <a:ext uri="{FF2B5EF4-FFF2-40B4-BE49-F238E27FC236}">
                  <a16:creationId xmlns:a16="http://schemas.microsoft.com/office/drawing/2014/main" id="{76026DF6-FC1E-4182-BA4D-68437466B3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1362" y="2628901"/>
              <a:ext cx="199827" cy="16022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6" name="グループ化 145">
              <a:extLst>
                <a:ext uri="{FF2B5EF4-FFF2-40B4-BE49-F238E27FC236}">
                  <a16:creationId xmlns:a16="http://schemas.microsoft.com/office/drawing/2014/main" id="{29F7F86F-3178-4190-ACA3-BE2D2317EA3B}"/>
                </a:ext>
              </a:extLst>
            </p:cNvPr>
            <p:cNvGrpSpPr/>
            <p:nvPr/>
          </p:nvGrpSpPr>
          <p:grpSpPr>
            <a:xfrm>
              <a:off x="2106588" y="1560197"/>
              <a:ext cx="99913" cy="108000"/>
              <a:chOff x="2097265" y="1568012"/>
              <a:chExt cx="99913" cy="108000"/>
            </a:xfrm>
          </p:grpSpPr>
          <p:sp>
            <p:nvSpPr>
              <p:cNvPr id="166" name="Line 140">
                <a:extLst>
                  <a:ext uri="{FF2B5EF4-FFF2-40B4-BE49-F238E27FC236}">
                    <a16:creationId xmlns:a16="http://schemas.microsoft.com/office/drawing/2014/main" id="{440E6889-CF99-4A8A-96E7-16E755FFD9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7221" y="1568012"/>
                <a:ext cx="0" cy="108000"/>
              </a:xfrm>
              <a:prstGeom prst="lin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Line 141">
                <a:extLst>
                  <a:ext uri="{FF2B5EF4-FFF2-40B4-BE49-F238E27FC236}">
                    <a16:creationId xmlns:a16="http://schemas.microsoft.com/office/drawing/2014/main" id="{D865A8C4-9F0B-466E-852E-413DA29884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97265" y="1568013"/>
                <a:ext cx="99913" cy="0"/>
              </a:xfrm>
              <a:prstGeom prst="lin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7" name="Rectangle 142">
              <a:extLst>
                <a:ext uri="{FF2B5EF4-FFF2-40B4-BE49-F238E27FC236}">
                  <a16:creationId xmlns:a16="http://schemas.microsoft.com/office/drawing/2014/main" id="{D64604D4-B1C5-42B3-A36F-39AA67CA43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6631" y="1590458"/>
              <a:ext cx="199827" cy="119866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Line 146">
              <a:extLst>
                <a:ext uri="{FF2B5EF4-FFF2-40B4-BE49-F238E27FC236}">
                  <a16:creationId xmlns:a16="http://schemas.microsoft.com/office/drawing/2014/main" id="{4265919E-9AC3-4365-B166-BCCBAB98DF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18121" y="1586702"/>
              <a:ext cx="0" cy="144000"/>
            </a:xfrm>
            <a:prstGeom prst="line">
              <a:avLst/>
            </a:prstGeom>
            <a:solidFill>
              <a:schemeClr val="bg1">
                <a:lumMod val="9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Line 147">
              <a:extLst>
                <a:ext uri="{FF2B5EF4-FFF2-40B4-BE49-F238E27FC236}">
                  <a16:creationId xmlns:a16="http://schemas.microsoft.com/office/drawing/2014/main" id="{4D2DAB62-BE92-4469-9714-2B4FFC4FEE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68164" y="1585935"/>
              <a:ext cx="99914" cy="0"/>
            </a:xfrm>
            <a:prstGeom prst="line">
              <a:avLst/>
            </a:prstGeom>
            <a:solidFill>
              <a:schemeClr val="bg1">
                <a:lumMod val="9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Rectangle 148">
              <a:extLst>
                <a:ext uri="{FF2B5EF4-FFF2-40B4-BE49-F238E27FC236}">
                  <a16:creationId xmlns:a16="http://schemas.microsoft.com/office/drawing/2014/main" id="{0716250E-507A-4588-9D8A-E450EA7E7E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8208" y="1604964"/>
              <a:ext cx="199827" cy="118415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Line 152">
              <a:extLst>
                <a:ext uri="{FF2B5EF4-FFF2-40B4-BE49-F238E27FC236}">
                  <a16:creationId xmlns:a16="http://schemas.microsoft.com/office/drawing/2014/main" id="{9DB9E881-295A-4025-8BE2-DA3EA19D0D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74935" y="2532776"/>
              <a:ext cx="0" cy="108000"/>
            </a:xfrm>
            <a:prstGeom prst="lin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Line 153">
              <a:extLst>
                <a:ext uri="{FF2B5EF4-FFF2-40B4-BE49-F238E27FC236}">
                  <a16:creationId xmlns:a16="http://schemas.microsoft.com/office/drawing/2014/main" id="{DBDEFFA8-5AD0-4215-8115-4D38BC82B1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24978" y="2537698"/>
              <a:ext cx="99914" cy="0"/>
            </a:xfrm>
            <a:prstGeom prst="lin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Rectangle 154">
              <a:extLst>
                <a:ext uri="{FF2B5EF4-FFF2-40B4-BE49-F238E27FC236}">
                  <a16:creationId xmlns:a16="http://schemas.microsoft.com/office/drawing/2014/main" id="{2471FAAA-F25B-43C9-A1CE-675A6674F9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9785" y="2576513"/>
              <a:ext cx="199827" cy="212608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9525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Line 153">
              <a:extLst>
                <a:ext uri="{FF2B5EF4-FFF2-40B4-BE49-F238E27FC236}">
                  <a16:creationId xmlns:a16="http://schemas.microsoft.com/office/drawing/2014/main" id="{300C6830-3A02-4491-AFC8-1C06C0A304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1319" y="2598107"/>
              <a:ext cx="99913" cy="0"/>
            </a:xfrm>
            <a:prstGeom prst="line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18094122-96FE-4373-A60F-1D9BB13756FB}"/>
                </a:ext>
              </a:extLst>
            </p:cNvPr>
            <p:cNvSpPr txBox="1"/>
            <p:nvPr/>
          </p:nvSpPr>
          <p:spPr>
            <a:xfrm rot="16200000">
              <a:off x="977542" y="1803231"/>
              <a:ext cx="1195192" cy="32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iR-31-5p</a:t>
              </a: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mock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4E24AE30-D920-4925-871C-C314A4E09B8E}"/>
                </a:ext>
              </a:extLst>
            </p:cNvPr>
            <p:cNvSpPr txBox="1"/>
            <p:nvPr/>
          </p:nvSpPr>
          <p:spPr>
            <a:xfrm rot="16200000">
              <a:off x="1956424" y="2866289"/>
              <a:ext cx="389870" cy="2051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テキスト ボックス 156">
              <a:extLst>
                <a:ext uri="{FF2B5EF4-FFF2-40B4-BE49-F238E27FC236}">
                  <a16:creationId xmlns:a16="http://schemas.microsoft.com/office/drawing/2014/main" id="{97C1BFF5-525F-48C6-A829-27653A702BF4}"/>
                </a:ext>
              </a:extLst>
            </p:cNvPr>
            <p:cNvSpPr txBox="1"/>
            <p:nvPr/>
          </p:nvSpPr>
          <p:spPr>
            <a:xfrm rot="16200000">
              <a:off x="2190881" y="2898349"/>
              <a:ext cx="448016" cy="2051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D86AEF86-6EC8-4934-8C0B-CDD4E1C4CB23}"/>
                </a:ext>
              </a:extLst>
            </p:cNvPr>
            <p:cNvSpPr txBox="1"/>
            <p:nvPr/>
          </p:nvSpPr>
          <p:spPr>
            <a:xfrm rot="16200000">
              <a:off x="2153747" y="3226163"/>
              <a:ext cx="1042558" cy="2051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iR-31-5p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H (10nM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527D01A3-6CFA-4E75-8249-83099DA83C13}"/>
                </a:ext>
              </a:extLst>
            </p:cNvPr>
            <p:cNvSpPr txBox="1"/>
            <p:nvPr/>
          </p:nvSpPr>
          <p:spPr>
            <a:xfrm rot="16200000">
              <a:off x="2417791" y="3226163"/>
              <a:ext cx="1042558" cy="2051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iR-31-5p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H (30nM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6C0A0AA1-26F3-41C1-908D-77654EF71BEC}"/>
                </a:ext>
              </a:extLst>
            </p:cNvPr>
            <p:cNvSpPr txBox="1"/>
            <p:nvPr/>
          </p:nvSpPr>
          <p:spPr>
            <a:xfrm>
              <a:off x="1955889" y="832294"/>
              <a:ext cx="372825" cy="195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SAS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1" name="直線コネクタ 160">
              <a:extLst>
                <a:ext uri="{FF2B5EF4-FFF2-40B4-BE49-F238E27FC236}">
                  <a16:creationId xmlns:a16="http://schemas.microsoft.com/office/drawing/2014/main" id="{58FAF34B-F430-49EC-B9B9-D2EABFBAA46A}"/>
                </a:ext>
              </a:extLst>
            </p:cNvPr>
            <p:cNvCxnSpPr/>
            <p:nvPr/>
          </p:nvCxnSpPr>
          <p:spPr>
            <a:xfrm>
              <a:off x="2411082" y="1427362"/>
              <a:ext cx="30003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直線コネクタ 161">
              <a:extLst>
                <a:ext uri="{FF2B5EF4-FFF2-40B4-BE49-F238E27FC236}">
                  <a16:creationId xmlns:a16="http://schemas.microsoft.com/office/drawing/2014/main" id="{391F0492-5A2A-4FD9-B1CF-9C8CF0B328EC}"/>
                </a:ext>
              </a:extLst>
            </p:cNvPr>
            <p:cNvCxnSpPr/>
            <p:nvPr/>
          </p:nvCxnSpPr>
          <p:spPr>
            <a:xfrm>
              <a:off x="2411082" y="1283417"/>
              <a:ext cx="54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798D4189-3832-48AE-9207-23F28B7BAEA6}"/>
                </a:ext>
              </a:extLst>
            </p:cNvPr>
            <p:cNvSpPr txBox="1"/>
            <p:nvPr/>
          </p:nvSpPr>
          <p:spPr>
            <a:xfrm>
              <a:off x="2449963" y="1106634"/>
              <a:ext cx="484276" cy="1674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テキスト ボックス 163">
              <a:extLst>
                <a:ext uri="{FF2B5EF4-FFF2-40B4-BE49-F238E27FC236}">
                  <a16:creationId xmlns:a16="http://schemas.microsoft.com/office/drawing/2014/main" id="{CC01095C-0006-4DD2-A793-84E3FF084B1C}"/>
                </a:ext>
              </a:extLst>
            </p:cNvPr>
            <p:cNvSpPr txBox="1"/>
            <p:nvPr/>
          </p:nvSpPr>
          <p:spPr>
            <a:xfrm>
              <a:off x="2307086" y="1259034"/>
              <a:ext cx="484276" cy="1674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Line 481">
              <a:extLst>
                <a:ext uri="{FF2B5EF4-FFF2-40B4-BE49-F238E27FC236}">
                  <a16:creationId xmlns:a16="http://schemas.microsoft.com/office/drawing/2014/main" id="{B45F2D0A-23ED-4453-A469-C8EF8E706E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42871" y="2787799"/>
              <a:ext cx="1174738" cy="1322"/>
            </a:xfrm>
            <a:prstGeom prst="line">
              <a:avLst/>
            </a:prstGeom>
            <a:noFill/>
            <a:ln w="12700" cmpd="sng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anchor="ctr"/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28307808-D136-44F4-9D93-C4D8710EE1E4}"/>
              </a:ext>
            </a:extLst>
          </p:cNvPr>
          <p:cNvSpPr txBox="1"/>
          <p:nvPr/>
        </p:nvSpPr>
        <p:spPr>
          <a:xfrm>
            <a:off x="139789" y="9456872"/>
            <a:ext cx="641290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 cells transfected with </a:t>
            </a: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miR-31-5p/-3p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hibitor, the expression levels </a:t>
            </a: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of miR-31-5p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miR-31-3p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were significantly lower than in mock- or 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control-transfected cells.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4575F3CF-37D2-4722-BB98-282F32A6BE4B}"/>
              </a:ext>
            </a:extLst>
          </p:cNvPr>
          <p:cNvSpPr txBox="1"/>
          <p:nvPr/>
        </p:nvSpPr>
        <p:spPr>
          <a:xfrm>
            <a:off x="149730" y="9301620"/>
            <a:ext cx="467553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igure S2.Effects of transfection with inhibitor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90676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7B9C7BF-29A9-4B5B-88C3-1BE3A9944C38}"/>
              </a:ext>
            </a:extLst>
          </p:cNvPr>
          <p:cNvSpPr txBox="1"/>
          <p:nvPr/>
        </p:nvSpPr>
        <p:spPr>
          <a:xfrm>
            <a:off x="2288413" y="833336"/>
            <a:ext cx="2201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ell growth curv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18FD311E-943F-4B4B-B3D5-6A55555356AA}"/>
              </a:ext>
            </a:extLst>
          </p:cNvPr>
          <p:cNvGrpSpPr/>
          <p:nvPr/>
        </p:nvGrpSpPr>
        <p:grpSpPr>
          <a:xfrm>
            <a:off x="1729624" y="1096117"/>
            <a:ext cx="3397750" cy="3740623"/>
            <a:chOff x="5140988" y="1623818"/>
            <a:chExt cx="3770137" cy="2355845"/>
          </a:xfrm>
        </p:grpSpPr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C2103038-2C2D-4D2B-940D-81081C8E1BA2}"/>
                </a:ext>
              </a:extLst>
            </p:cNvPr>
            <p:cNvGrpSpPr/>
            <p:nvPr/>
          </p:nvGrpSpPr>
          <p:grpSpPr>
            <a:xfrm>
              <a:off x="5140988" y="1623818"/>
              <a:ext cx="3420150" cy="2355845"/>
              <a:chOff x="5184470" y="2548522"/>
              <a:chExt cx="3420150" cy="2355845"/>
            </a:xfrm>
          </p:grpSpPr>
          <p:grpSp>
            <p:nvGrpSpPr>
              <p:cNvPr id="9" name="グループ化 8">
                <a:extLst>
                  <a:ext uri="{FF2B5EF4-FFF2-40B4-BE49-F238E27FC236}">
                    <a16:creationId xmlns:a16="http://schemas.microsoft.com/office/drawing/2014/main" id="{05ED2728-6489-400A-8B2F-CB6E757B27BD}"/>
                  </a:ext>
                </a:extLst>
              </p:cNvPr>
              <p:cNvGrpSpPr/>
              <p:nvPr/>
            </p:nvGrpSpPr>
            <p:grpSpPr>
              <a:xfrm>
                <a:off x="5184470" y="2548522"/>
                <a:ext cx="3420150" cy="2355845"/>
                <a:chOff x="5084694" y="1664995"/>
                <a:chExt cx="3420150" cy="2355845"/>
              </a:xfrm>
            </p:grpSpPr>
            <p:graphicFrame>
              <p:nvGraphicFramePr>
                <p:cNvPr id="11" name="グラフ 10">
                  <a:extLst>
                    <a:ext uri="{FF2B5EF4-FFF2-40B4-BE49-F238E27FC236}">
                      <a16:creationId xmlns:a16="http://schemas.microsoft.com/office/drawing/2014/main" id="{6BDC13FB-A8CE-4050-985E-AC57D9DCCC76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816142791"/>
                    </p:ext>
                  </p:extLst>
                </p:nvPr>
              </p:nvGraphicFramePr>
              <p:xfrm>
                <a:off x="5347417" y="1812071"/>
                <a:ext cx="3157427" cy="220876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12" name="テキスト ボックス 11">
                  <a:extLst>
                    <a:ext uri="{FF2B5EF4-FFF2-40B4-BE49-F238E27FC236}">
                      <a16:creationId xmlns:a16="http://schemas.microsoft.com/office/drawing/2014/main" id="{C004A76F-DE98-4320-979A-F41831D870F9}"/>
                    </a:ext>
                  </a:extLst>
                </p:cNvPr>
                <p:cNvSpPr txBox="1"/>
                <p:nvPr/>
              </p:nvSpPr>
              <p:spPr>
                <a:xfrm>
                  <a:off x="7638232" y="2759153"/>
                  <a:ext cx="378135" cy="1356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ja-JP" alt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＊</a:t>
                  </a:r>
                </a:p>
              </p:txBody>
            </p:sp>
            <p:sp>
              <p:nvSpPr>
                <p:cNvPr id="13" name="テキスト ボックス 12">
                  <a:extLst>
                    <a:ext uri="{FF2B5EF4-FFF2-40B4-BE49-F238E27FC236}">
                      <a16:creationId xmlns:a16="http://schemas.microsoft.com/office/drawing/2014/main" id="{CFE5D3BB-6A92-4141-8FCB-961F7815D3FC}"/>
                    </a:ext>
                  </a:extLst>
                </p:cNvPr>
                <p:cNvSpPr txBox="1"/>
                <p:nvPr/>
              </p:nvSpPr>
              <p:spPr>
                <a:xfrm>
                  <a:off x="8108196" y="2543065"/>
                  <a:ext cx="378135" cy="1356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ja-JP" alt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＊</a:t>
                  </a:r>
                </a:p>
              </p:txBody>
            </p:sp>
            <p:sp>
              <p:nvSpPr>
                <p:cNvPr id="14" name="テキスト ボックス 13">
                  <a:extLst>
                    <a:ext uri="{FF2B5EF4-FFF2-40B4-BE49-F238E27FC236}">
                      <a16:creationId xmlns:a16="http://schemas.microsoft.com/office/drawing/2014/main" id="{19B11B65-4749-426F-9F81-4A34361CD586}"/>
                    </a:ext>
                  </a:extLst>
                </p:cNvPr>
                <p:cNvSpPr txBox="1"/>
                <p:nvPr/>
              </p:nvSpPr>
              <p:spPr>
                <a:xfrm>
                  <a:off x="7626954" y="2655544"/>
                  <a:ext cx="378135" cy="1356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ja-JP" alt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＊</a:t>
                  </a:r>
                </a:p>
              </p:txBody>
            </p:sp>
            <p:sp>
              <p:nvSpPr>
                <p:cNvPr id="15" name="テキスト ボックス 14">
                  <a:extLst>
                    <a:ext uri="{FF2B5EF4-FFF2-40B4-BE49-F238E27FC236}">
                      <a16:creationId xmlns:a16="http://schemas.microsoft.com/office/drawing/2014/main" id="{B36C6806-4950-4E90-9EB5-93A7850E9D5D}"/>
                    </a:ext>
                  </a:extLst>
                </p:cNvPr>
                <p:cNvSpPr txBox="1"/>
                <p:nvPr/>
              </p:nvSpPr>
              <p:spPr>
                <a:xfrm>
                  <a:off x="8089683" y="2433588"/>
                  <a:ext cx="378135" cy="1356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ja-JP" alt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＊</a:t>
                  </a:r>
                </a:p>
              </p:txBody>
            </p:sp>
            <p:sp>
              <p:nvSpPr>
                <p:cNvPr id="16" name="テキスト ボックス 15">
                  <a:extLst>
                    <a:ext uri="{FF2B5EF4-FFF2-40B4-BE49-F238E27FC236}">
                      <a16:creationId xmlns:a16="http://schemas.microsoft.com/office/drawing/2014/main" id="{0E37E061-FFCA-42EF-83FD-36F5A3121467}"/>
                    </a:ext>
                  </a:extLst>
                </p:cNvPr>
                <p:cNvSpPr txBox="1"/>
                <p:nvPr/>
              </p:nvSpPr>
              <p:spPr>
                <a:xfrm rot="16200000">
                  <a:off x="4080128" y="2669561"/>
                  <a:ext cx="2248187" cy="2390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 number(×10</a:t>
                  </a:r>
                  <a:r>
                    <a: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⁴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64D0ACFF-BEA7-47FF-9160-BBFFCFC07E72}"/>
                  </a:ext>
                </a:extLst>
              </p:cNvPr>
              <p:cNvSpPr txBox="1"/>
              <p:nvPr/>
            </p:nvSpPr>
            <p:spPr>
              <a:xfrm>
                <a:off x="7880076" y="3012319"/>
                <a:ext cx="687519" cy="1356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.S.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9FB96D3C-7C9B-4343-A685-4267F460FEAA}"/>
                </a:ext>
              </a:extLst>
            </p:cNvPr>
            <p:cNvSpPr txBox="1"/>
            <p:nvPr/>
          </p:nvSpPr>
          <p:spPr>
            <a:xfrm>
              <a:off x="8396125" y="3669451"/>
              <a:ext cx="515000" cy="1356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136E5A70-BB76-4FB4-AC35-D335228F489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0784627"/>
              </p:ext>
            </p:extLst>
          </p:nvPr>
        </p:nvGraphicFramePr>
        <p:xfrm>
          <a:off x="1966397" y="4992293"/>
          <a:ext cx="2895109" cy="33464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D216A33-E2C1-49A1-AC5D-833A11764BD1}"/>
              </a:ext>
            </a:extLst>
          </p:cNvPr>
          <p:cNvSpPr txBox="1"/>
          <p:nvPr/>
        </p:nvSpPr>
        <p:spPr>
          <a:xfrm>
            <a:off x="4222819" y="5468072"/>
            <a:ext cx="6493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EA7CD2B-0A7D-44B5-8107-842C49B091DA}"/>
              </a:ext>
            </a:extLst>
          </p:cNvPr>
          <p:cNvSpPr txBox="1"/>
          <p:nvPr/>
        </p:nvSpPr>
        <p:spPr>
          <a:xfrm>
            <a:off x="3598321" y="3351697"/>
            <a:ext cx="3781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＊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2A9F2FF-23A2-448F-BDED-A541078A08D1}"/>
              </a:ext>
            </a:extLst>
          </p:cNvPr>
          <p:cNvSpPr txBox="1"/>
          <p:nvPr/>
        </p:nvSpPr>
        <p:spPr>
          <a:xfrm>
            <a:off x="4014612" y="6708972"/>
            <a:ext cx="3571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＊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B258BAF-8FA4-4E39-9CAF-52A05A8C793C}"/>
              </a:ext>
            </a:extLst>
          </p:cNvPr>
          <p:cNvSpPr txBox="1"/>
          <p:nvPr/>
        </p:nvSpPr>
        <p:spPr>
          <a:xfrm>
            <a:off x="4446321" y="6302593"/>
            <a:ext cx="3571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＊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219A86D-0247-421F-853E-8E789E8D8859}"/>
              </a:ext>
            </a:extLst>
          </p:cNvPr>
          <p:cNvSpPr txBox="1"/>
          <p:nvPr/>
        </p:nvSpPr>
        <p:spPr>
          <a:xfrm>
            <a:off x="4044261" y="7014484"/>
            <a:ext cx="3571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＊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9BFB1EF-3142-4E8A-A0AD-9655540322BE}"/>
              </a:ext>
            </a:extLst>
          </p:cNvPr>
          <p:cNvSpPr txBox="1"/>
          <p:nvPr/>
        </p:nvSpPr>
        <p:spPr>
          <a:xfrm>
            <a:off x="4456381" y="6030361"/>
            <a:ext cx="3571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＊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92B9F91-1762-4DFB-96A1-FF66ACB29214}"/>
              </a:ext>
            </a:extLst>
          </p:cNvPr>
          <p:cNvSpPr txBox="1"/>
          <p:nvPr/>
        </p:nvSpPr>
        <p:spPr>
          <a:xfrm>
            <a:off x="4667179" y="7884950"/>
            <a:ext cx="4863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EBB2AD9-0433-471E-BDE5-43ACC895ABC6}"/>
              </a:ext>
            </a:extLst>
          </p:cNvPr>
          <p:cNvSpPr txBox="1"/>
          <p:nvPr/>
        </p:nvSpPr>
        <p:spPr>
          <a:xfrm rot="16200000">
            <a:off x="430145" y="6365443"/>
            <a:ext cx="28235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ell number(×10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⁴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429255F-AFEB-46E2-BFD7-461A013AD939}"/>
              </a:ext>
            </a:extLst>
          </p:cNvPr>
          <p:cNvSpPr txBox="1"/>
          <p:nvPr/>
        </p:nvSpPr>
        <p:spPr>
          <a:xfrm>
            <a:off x="3293490" y="1195803"/>
            <a:ext cx="465301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AS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8369385-EB34-4262-BFFC-F4FB944133A0}"/>
              </a:ext>
            </a:extLst>
          </p:cNvPr>
          <p:cNvSpPr txBox="1"/>
          <p:nvPr/>
        </p:nvSpPr>
        <p:spPr>
          <a:xfrm>
            <a:off x="3293490" y="4845937"/>
            <a:ext cx="7507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SC-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FA19408-7655-4690-851B-AC7B7B9105C9}"/>
              </a:ext>
            </a:extLst>
          </p:cNvPr>
          <p:cNvSpPr txBox="1"/>
          <p:nvPr/>
        </p:nvSpPr>
        <p:spPr>
          <a:xfrm>
            <a:off x="73240" y="9278738"/>
            <a:ext cx="676881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o evaluate the effect of </a:t>
            </a:r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miR-31-5p/3p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hibition on cellular proliferation, we analyzed cellular growth in and </a:t>
            </a:r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miR-31-5p/3p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hibit cells, mock cells and negative control cells. These cells were seeded in 6-well plates at a density of 5 × 10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⁴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viable cells. At the indicated time points, the cells were </a:t>
            </a:r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trypsinized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and counted in triplicate using the cell counter(Thermo Fisher Scientific) The number of cells was counted for each hour. All experiments were carried out in triplicate. *</a:t>
            </a:r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&lt; 0.05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19A7AD30-9C9C-4B2D-9B30-28EAD5E98456}"/>
              </a:ext>
            </a:extLst>
          </p:cNvPr>
          <p:cNvSpPr txBox="1"/>
          <p:nvPr/>
        </p:nvSpPr>
        <p:spPr>
          <a:xfrm>
            <a:off x="89188" y="9135229"/>
            <a:ext cx="481684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igure S3. Proliferation assay with inhibitor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CBDD225A-A99D-4CBD-845A-2EFDF6CC60D4}"/>
              </a:ext>
            </a:extLst>
          </p:cNvPr>
          <p:cNvSpPr txBox="1"/>
          <p:nvPr/>
        </p:nvSpPr>
        <p:spPr>
          <a:xfrm>
            <a:off x="216930" y="107912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42766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6B8DADA-FBD5-4B59-8D62-82C805BF4FB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8581" y="1737880"/>
            <a:ext cx="1242000" cy="930605"/>
          </a:xfrm>
          <a:prstGeom prst="rect">
            <a:avLst/>
          </a:prstGeom>
          <a:ln>
            <a:solidFill>
              <a:srgbClr val="1744A9"/>
            </a:solidFill>
          </a:ln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FF9F0082-4294-466F-8707-A698FC005AF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7977" y="1729566"/>
            <a:ext cx="1242743" cy="931162"/>
          </a:xfrm>
          <a:prstGeom prst="rect">
            <a:avLst/>
          </a:prstGeom>
          <a:ln>
            <a:solidFill>
              <a:srgbClr val="1744A9"/>
            </a:solidFill>
          </a:ln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F0ADE6FE-86A0-4BE1-ABCA-3E7345E995A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9638" y="1733465"/>
            <a:ext cx="1242000" cy="930605"/>
          </a:xfrm>
          <a:prstGeom prst="rect">
            <a:avLst/>
          </a:prstGeom>
          <a:ln>
            <a:solidFill>
              <a:srgbClr val="1744A9"/>
            </a:solidFill>
          </a:ln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DB936DD1-4BA1-4F32-A51E-D14D17B939B7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2530" y="1733466"/>
            <a:ext cx="1242000" cy="930605"/>
          </a:xfrm>
          <a:prstGeom prst="rect">
            <a:avLst/>
          </a:prstGeom>
          <a:ln>
            <a:solidFill>
              <a:srgbClr val="1744A9"/>
            </a:solidFill>
          </a:ln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E381EBE-B8D9-4106-8E1B-6A37A28D49B3}"/>
              </a:ext>
            </a:extLst>
          </p:cNvPr>
          <p:cNvSpPr txBox="1"/>
          <p:nvPr/>
        </p:nvSpPr>
        <p:spPr>
          <a:xfrm>
            <a:off x="744251" y="1530714"/>
            <a:ext cx="1530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03B9BE3-84B1-4D4E-9121-5D8326A47E3D}"/>
              </a:ext>
            </a:extLst>
          </p:cNvPr>
          <p:cNvSpPr txBox="1"/>
          <p:nvPr/>
        </p:nvSpPr>
        <p:spPr>
          <a:xfrm>
            <a:off x="2169279" y="1515553"/>
            <a:ext cx="1530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EE2A7D1-DC2F-422D-9D96-AC941BA25455}"/>
              </a:ext>
            </a:extLst>
          </p:cNvPr>
          <p:cNvSpPr txBox="1"/>
          <p:nvPr/>
        </p:nvSpPr>
        <p:spPr>
          <a:xfrm>
            <a:off x="3577513" y="1530767"/>
            <a:ext cx="1530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miR-31-5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Inhibitor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C6ECB56-4F8C-40E1-8ADA-3A6A6FA629B0}"/>
              </a:ext>
            </a:extLst>
          </p:cNvPr>
          <p:cNvSpPr txBox="1"/>
          <p:nvPr/>
        </p:nvSpPr>
        <p:spPr>
          <a:xfrm>
            <a:off x="5041759" y="1520535"/>
            <a:ext cx="1530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miR-31-3p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Inhibitor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5D9F7076-DE69-49FD-9EC1-C247995CE1FC}"/>
              </a:ext>
            </a:extLst>
          </p:cNvPr>
          <p:cNvPicPr preferRelativeResize="0">
            <a:picLocks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1503" y="2804603"/>
            <a:ext cx="1242000" cy="931162"/>
          </a:xfrm>
          <a:prstGeom prst="rect">
            <a:avLst/>
          </a:prstGeom>
          <a:ln>
            <a:solidFill>
              <a:srgbClr val="1744A9"/>
            </a:solidFill>
          </a:ln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9F2BC49F-9684-44CA-BDAA-62842757F70F}"/>
              </a:ext>
            </a:extLst>
          </p:cNvPr>
          <p:cNvPicPr preferRelativeResize="0">
            <a:picLocks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2031" y="2804601"/>
            <a:ext cx="1242000" cy="931162"/>
          </a:xfrm>
          <a:prstGeom prst="rect">
            <a:avLst/>
          </a:prstGeom>
          <a:ln>
            <a:solidFill>
              <a:srgbClr val="1744A9"/>
            </a:solidFill>
          </a:ln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0F278FFE-E6EB-4B81-9FF3-6363338F79D5}"/>
              </a:ext>
            </a:extLst>
          </p:cNvPr>
          <p:cNvPicPr preferRelativeResize="0">
            <a:picLocks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5192" y="2804601"/>
            <a:ext cx="1242000" cy="931162"/>
          </a:xfrm>
          <a:prstGeom prst="rect">
            <a:avLst/>
          </a:prstGeom>
          <a:ln>
            <a:solidFill>
              <a:srgbClr val="1744A9"/>
            </a:solidFill>
          </a:ln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3CC48FB2-02FA-4A8E-8B4A-9BE9DDE3B495}"/>
              </a:ext>
            </a:extLst>
          </p:cNvPr>
          <p:cNvPicPr preferRelativeResize="0">
            <a:picLocks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2530" y="2804601"/>
            <a:ext cx="1242000" cy="931162"/>
          </a:xfrm>
          <a:prstGeom prst="rect">
            <a:avLst/>
          </a:prstGeom>
          <a:ln>
            <a:solidFill>
              <a:srgbClr val="1744A9"/>
            </a:solidFill>
          </a:ln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8172D11-EDE8-4F17-9318-95AC7EC30A39}"/>
              </a:ext>
            </a:extLst>
          </p:cNvPr>
          <p:cNvSpPr txBox="1"/>
          <p:nvPr/>
        </p:nvSpPr>
        <p:spPr>
          <a:xfrm>
            <a:off x="369057" y="2052174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S</a:t>
            </a:r>
            <a:endParaRPr kumimoji="0" lang="ja-JP" altLang="en-US" sz="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4C27A72-9A1C-4765-A03D-0F44A430EFAC}"/>
              </a:ext>
            </a:extLst>
          </p:cNvPr>
          <p:cNvSpPr txBox="1"/>
          <p:nvPr/>
        </p:nvSpPr>
        <p:spPr>
          <a:xfrm>
            <a:off x="309343" y="3125487"/>
            <a:ext cx="510881" cy="218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SC-2</a:t>
            </a:r>
            <a:endParaRPr kumimoji="0" lang="ja-JP" altLang="en-US" sz="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CD4EAD2-F886-442E-AD5A-D44E999615FA}"/>
              </a:ext>
            </a:extLst>
          </p:cNvPr>
          <p:cNvSpPr txBox="1"/>
          <p:nvPr/>
        </p:nvSpPr>
        <p:spPr>
          <a:xfrm>
            <a:off x="2592042" y="1064112"/>
            <a:ext cx="2201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igration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ssa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3DA1E38-8C4D-441A-BF09-1543B9F2AE97}"/>
              </a:ext>
            </a:extLst>
          </p:cNvPr>
          <p:cNvSpPr txBox="1"/>
          <p:nvPr/>
        </p:nvSpPr>
        <p:spPr>
          <a:xfrm>
            <a:off x="2469957" y="4000107"/>
            <a:ext cx="2201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nvasion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ssa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7C8070CF-9C4D-4719-B336-4649BB887AC5}"/>
              </a:ext>
            </a:extLst>
          </p:cNvPr>
          <p:cNvPicPr preferRelativeResize="0">
            <a:picLocks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6534" y="4590445"/>
            <a:ext cx="1267200" cy="950400"/>
          </a:xfrm>
          <a:prstGeom prst="rect">
            <a:avLst/>
          </a:prstGeom>
          <a:ln>
            <a:solidFill>
              <a:srgbClr val="1744A9"/>
            </a:solidFill>
          </a:ln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7659D622-C6D0-444F-B90A-EDAA51B39FA8}"/>
              </a:ext>
            </a:extLst>
          </p:cNvPr>
          <p:cNvPicPr preferRelativeResize="0">
            <a:picLocks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7776" y="4590445"/>
            <a:ext cx="1288223" cy="950400"/>
          </a:xfrm>
          <a:prstGeom prst="rect">
            <a:avLst/>
          </a:prstGeom>
          <a:ln>
            <a:solidFill>
              <a:srgbClr val="1744A9"/>
            </a:solidFill>
          </a:ln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56D4FD36-E47C-4FBE-99B0-12EDB6627908}"/>
              </a:ext>
            </a:extLst>
          </p:cNvPr>
          <p:cNvPicPr preferRelativeResize="0">
            <a:picLocks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7833" y="4604051"/>
            <a:ext cx="1267200" cy="950400"/>
          </a:xfrm>
          <a:prstGeom prst="rect">
            <a:avLst/>
          </a:prstGeom>
          <a:ln>
            <a:solidFill>
              <a:srgbClr val="1744A9"/>
            </a:solidFill>
          </a:ln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012E1776-55A8-4541-AE71-EDD92C8889F0}"/>
              </a:ext>
            </a:extLst>
          </p:cNvPr>
          <p:cNvPicPr preferRelativeResize="0">
            <a:picLocks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6243" y="4590445"/>
            <a:ext cx="1267200" cy="950400"/>
          </a:xfrm>
          <a:prstGeom prst="rect">
            <a:avLst/>
          </a:prstGeom>
          <a:ln>
            <a:solidFill>
              <a:srgbClr val="1744A9"/>
            </a:solidFill>
          </a:ln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B5D6774-C648-41BA-8B11-CAB4A1F2ACEB}"/>
              </a:ext>
            </a:extLst>
          </p:cNvPr>
          <p:cNvSpPr txBox="1"/>
          <p:nvPr/>
        </p:nvSpPr>
        <p:spPr>
          <a:xfrm>
            <a:off x="3729190" y="4382956"/>
            <a:ext cx="13028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i="1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iR-31-5p</a:t>
            </a:r>
            <a:r>
              <a:rPr kumimoji="1" lang="en-US" altLang="ja-JP" sz="8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Inhibitor</a:t>
            </a:r>
            <a:endParaRPr kumimoji="1" lang="ja-JP" altLang="en-US" sz="80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1BCED20-971A-47A0-91C1-A343C536CF5A}"/>
              </a:ext>
            </a:extLst>
          </p:cNvPr>
          <p:cNvSpPr txBox="1"/>
          <p:nvPr/>
        </p:nvSpPr>
        <p:spPr>
          <a:xfrm>
            <a:off x="5131634" y="4390714"/>
            <a:ext cx="13028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i="1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iR-31-3p</a:t>
            </a:r>
            <a:r>
              <a:rPr kumimoji="1" lang="en-US" altLang="ja-JP" sz="8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Inhibitor</a:t>
            </a:r>
            <a:endParaRPr kumimoji="1" lang="ja-JP" altLang="en-US" sz="80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id="{A138A5B2-555D-4AE0-A925-267898A4FDA2}"/>
              </a:ext>
            </a:extLst>
          </p:cNvPr>
          <p:cNvPicPr preferRelativeResize="0">
            <a:picLocks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sharpenSoften amount="50000"/>
                    </a14:imgEffect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200" y="5659569"/>
            <a:ext cx="1267200" cy="950400"/>
          </a:xfrm>
          <a:prstGeom prst="rect">
            <a:avLst/>
          </a:prstGeom>
          <a:ln>
            <a:solidFill>
              <a:srgbClr val="1744A9"/>
            </a:solidFill>
          </a:ln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54B048FB-545C-4B3E-BB3F-BAC294A67B02}"/>
              </a:ext>
            </a:extLst>
          </p:cNvPr>
          <p:cNvPicPr preferRelativeResize="0">
            <a:picLocks/>
          </p:cNvPicPr>
          <p:nvPr/>
        </p:nvPicPr>
        <p:blipFill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sharpenSoften amount="50000"/>
                    </a14:imgEffect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5850" y="5656091"/>
            <a:ext cx="1267200" cy="950400"/>
          </a:xfrm>
          <a:prstGeom prst="rect">
            <a:avLst/>
          </a:prstGeom>
          <a:ln>
            <a:solidFill>
              <a:srgbClr val="1744A9"/>
            </a:solidFill>
          </a:ln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D556B9A9-E1F6-4B2C-A77A-03FA1DDE838E}"/>
              </a:ext>
            </a:extLst>
          </p:cNvPr>
          <p:cNvPicPr preferRelativeResize="0">
            <a:picLocks/>
          </p:cNvPicPr>
          <p:nvPr/>
        </p:nvPicPr>
        <p:blipFill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sharpenSoften amount="50000"/>
                    </a14:imgEffect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6243" y="5656091"/>
            <a:ext cx="1267200" cy="950400"/>
          </a:xfrm>
          <a:prstGeom prst="rect">
            <a:avLst/>
          </a:prstGeom>
          <a:ln>
            <a:solidFill>
              <a:srgbClr val="1744A9"/>
            </a:solidFill>
          </a:ln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A30F30E9-1EDC-4695-A0A5-504D02DE4664}"/>
              </a:ext>
            </a:extLst>
          </p:cNvPr>
          <p:cNvPicPr preferRelativeResize="0">
            <a:picLocks/>
          </p:cNvPicPr>
          <p:nvPr/>
        </p:nvPicPr>
        <p:blipFill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sharpenSoften amount="50000"/>
                    </a14:imgEffect>
                    <a14:imgEffect>
                      <a14:colorTemperature colorTemp="8800"/>
                    </a14:imgEffect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5419" y="5656091"/>
            <a:ext cx="1267200" cy="950400"/>
          </a:xfrm>
          <a:prstGeom prst="rect">
            <a:avLst/>
          </a:prstGeom>
          <a:ln>
            <a:solidFill>
              <a:srgbClr val="1744A9"/>
            </a:solidFill>
          </a:ln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706AFD2-B8B1-46A2-8C80-31E276C42720}"/>
              </a:ext>
            </a:extLst>
          </p:cNvPr>
          <p:cNvSpPr txBox="1"/>
          <p:nvPr/>
        </p:nvSpPr>
        <p:spPr>
          <a:xfrm>
            <a:off x="736936" y="4388489"/>
            <a:ext cx="1530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60CF7C91-98B8-4380-9B5D-B20B5EE59446}"/>
              </a:ext>
            </a:extLst>
          </p:cNvPr>
          <p:cNvSpPr txBox="1"/>
          <p:nvPr/>
        </p:nvSpPr>
        <p:spPr>
          <a:xfrm>
            <a:off x="2161964" y="4373328"/>
            <a:ext cx="1530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1BAD1C24-075F-4F53-954B-2EAEFBAE7FC5}"/>
              </a:ext>
            </a:extLst>
          </p:cNvPr>
          <p:cNvSpPr txBox="1"/>
          <p:nvPr/>
        </p:nvSpPr>
        <p:spPr>
          <a:xfrm>
            <a:off x="461404" y="5016307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S</a:t>
            </a:r>
            <a:endParaRPr kumimoji="0" lang="ja-JP" altLang="en-US" sz="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84F0B582-4C9D-4DC5-9BCB-76B45A66DD50}"/>
              </a:ext>
            </a:extLst>
          </p:cNvPr>
          <p:cNvSpPr txBox="1"/>
          <p:nvPr/>
        </p:nvSpPr>
        <p:spPr>
          <a:xfrm>
            <a:off x="335891" y="6089620"/>
            <a:ext cx="510881" cy="218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SC-2</a:t>
            </a:r>
            <a:endParaRPr kumimoji="0" lang="ja-JP" altLang="en-US" sz="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174B56F-996D-4568-87A6-79A6DAE6923A}"/>
              </a:ext>
            </a:extLst>
          </p:cNvPr>
          <p:cNvSpPr txBox="1"/>
          <p:nvPr/>
        </p:nvSpPr>
        <p:spPr>
          <a:xfrm>
            <a:off x="190857" y="9256577"/>
            <a:ext cx="647628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Figure S4. Photomicrographs of migration and invasion assay following </a:t>
            </a: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miR-31-5p/3p</a:t>
            </a:r>
            <a:r>
              <a:rPr lang="ja-JP" alt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hibitor  transfection into HNSCC cells.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Inhibition of </a:t>
            </a: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miR-31-5p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miR-31-3p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attenuated the markedly decreased the migration and invasion of SAS and HSC-2 cells. 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96AD407-08B1-4E92-B279-E70340FEAF47}"/>
              </a:ext>
            </a:extLst>
          </p:cNvPr>
          <p:cNvSpPr txBox="1"/>
          <p:nvPr/>
        </p:nvSpPr>
        <p:spPr>
          <a:xfrm>
            <a:off x="6088144" y="3729681"/>
            <a:ext cx="952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×20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B5AF4FA4-AB8F-4600-B0DF-A41FB397495C}"/>
              </a:ext>
            </a:extLst>
          </p:cNvPr>
          <p:cNvSpPr txBox="1"/>
          <p:nvPr/>
        </p:nvSpPr>
        <p:spPr>
          <a:xfrm>
            <a:off x="5993800" y="6595211"/>
            <a:ext cx="952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×20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408592A-B002-4058-B086-31FBBCA8BD26}"/>
              </a:ext>
            </a:extLst>
          </p:cNvPr>
          <p:cNvSpPr txBox="1"/>
          <p:nvPr/>
        </p:nvSpPr>
        <p:spPr>
          <a:xfrm>
            <a:off x="216930" y="107912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16656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9</TotalTime>
  <Words>522</Words>
  <Application>Microsoft Office PowerPoint</Application>
  <PresentationFormat>A4 210 x 297 mm</PresentationFormat>
  <Paragraphs>159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819055668940</dc:creator>
  <cp:lastModifiedBy>819055668940</cp:lastModifiedBy>
  <cp:revision>45</cp:revision>
  <dcterms:created xsi:type="dcterms:W3CDTF">2021-05-24T06:22:54Z</dcterms:created>
  <dcterms:modified xsi:type="dcterms:W3CDTF">2021-06-06T13:52:46Z</dcterms:modified>
</cp:coreProperties>
</file>